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4" d="100"/>
          <a:sy n="64" d="100"/>
        </p:scale>
        <p:origin x="-153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83905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416393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744965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8907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674142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979352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486052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77884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59618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985772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60800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03895A-7C4E-433C-ADAB-905B7F98298F}" type="datetimeFigureOut">
              <a:rPr lang="en-US" smtClean="0"/>
              <a:pPr/>
              <a:t>6/1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F36DB-5405-4E08-B2CB-ADD3665D893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8041497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34" Type="http://schemas.openxmlformats.org/officeDocument/2006/relationships/image" Target="../media/image33.tiff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tiff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5.tiff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4" name="TextBox 199"/>
          <p:cNvSpPr txBox="1">
            <a:spLocks noChangeArrowheads="1"/>
          </p:cNvSpPr>
          <p:nvPr/>
        </p:nvSpPr>
        <p:spPr bwMode="auto">
          <a:xfrm>
            <a:off x="56151" y="266520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6" name="TextBox 199"/>
          <p:cNvSpPr txBox="1">
            <a:spLocks noChangeArrowheads="1"/>
          </p:cNvSpPr>
          <p:nvPr/>
        </p:nvSpPr>
        <p:spPr bwMode="auto">
          <a:xfrm>
            <a:off x="6124456" y="270587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79" name="Group 78"/>
          <p:cNvGrpSpPr/>
          <p:nvPr/>
        </p:nvGrpSpPr>
        <p:grpSpPr>
          <a:xfrm>
            <a:off x="6171830" y="306383"/>
            <a:ext cx="2829529" cy="2199619"/>
            <a:chOff x="845093" y="4064677"/>
            <a:chExt cx="2829529" cy="2199619"/>
          </a:xfrm>
        </p:grpSpPr>
        <p:pic>
          <p:nvPicPr>
            <p:cNvPr id="414" name="Picture 6" descr="D:\Sumit\Breast manuscript HSP70-2\Manuscript HSP70-2 in breast\HSP70-2 paper Sumit\Breast cancer HSP70-2 2013\HSP70-2 in breast cancer\Latest 20X images 0ct14\20X\IDC PCNA HSP70-2 for grades\H&amp;E\grade 3 H&amp;E\370T Grade 3 H&amp;E 20X 8.jpg"/>
            <p:cNvPicPr>
              <a:picLocks noChangeAspect="1" noChangeArrowheads="1"/>
            </p:cNvPicPr>
            <p:nvPr/>
          </p:nvPicPr>
          <p:blipFill>
            <a:blip r:embed="rId2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1032964" y="5613993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15" name="Picture 7" descr="D:\Sumit\Breast manuscript HSP70-2\Manuscript HSP70-2 in breast\HSP70-2 paper Sumit\Breast cancer HSP70-2 2013\HSP70-2 in breast cancer\Latest 20X images 0ct14\20X\IDC PCNA HSP70-2 for grades\H&amp;E\grade 1 H&amp;E\381T Grade 1 H&amp;E 20X 4.jpg"/>
            <p:cNvPicPr>
              <a:picLocks noChangeAspect="1" noChangeArrowheads="1"/>
            </p:cNvPicPr>
            <p:nvPr/>
          </p:nvPicPr>
          <p:blipFill>
            <a:blip r:embed="rId3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1032964" y="4260978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16" name="Picture 8" descr="D:\Sumit\Breast manuscript HSP70-2\Manuscript HSP70-2 in breast\HSP70-2 paper Sumit\Breast cancer HSP70-2 2013\HSP70-2 in breast cancer\Latest 20X images 0ct14\20X\IDC PCNA HSP70-2 for grades\PCNA grades\266T Grade 2 PCNA 20X 2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1916341" y="4260978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17" name="Picture 9" descr="D:\Sumit\Breast manuscript HSP70-2\Manuscript HSP70-2 in breast\HSP70-2 paper Sumit\Breast cancer HSP70-2 2013\HSP70-2 in breast cancer\Latest 20X images 0ct14\20X\IDC PCNA HSP70-2 for grades\PCNA grades\329T Grade 2 PCNA 20X 5.jpg"/>
            <p:cNvPicPr>
              <a:picLocks noChangeAspect="1" noChangeArrowheads="1"/>
            </p:cNvPicPr>
            <p:nvPr/>
          </p:nvPicPr>
          <p:blipFill>
            <a:blip r:embed="rId5" cstate="print">
              <a:lum contrast="10000"/>
            </a:blip>
            <a:srcRect/>
            <a:stretch>
              <a:fillRect/>
            </a:stretch>
          </p:blipFill>
          <p:spPr bwMode="auto">
            <a:xfrm>
              <a:off x="1920775" y="4940971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18" name="Picture 10" descr="D:\Sumit\Breast manuscript HSP70-2\Manuscript HSP70-2 in breast\HSP70-2 paper Sumit\Breast cancer HSP70-2 2013\HSP70-2 in breast cancer\Latest 20X images 0ct14\20X\IDC PCNA HSP70-2 for grades\PCNA grades\370T Grade 3 PCNA 20X 4.jpg"/>
            <p:cNvPicPr>
              <a:picLocks noChangeAspect="1" noChangeArrowheads="1"/>
            </p:cNvPicPr>
            <p:nvPr/>
          </p:nvPicPr>
          <p:blipFill>
            <a:blip r:embed="rId6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1920900" y="5624216"/>
              <a:ext cx="856751" cy="640080"/>
            </a:xfrm>
            <a:prstGeom prst="rect">
              <a:avLst/>
            </a:prstGeom>
            <a:noFill/>
          </p:spPr>
        </p:pic>
        <p:sp>
          <p:nvSpPr>
            <p:cNvPr id="419" name="Text Box 12"/>
            <p:cNvSpPr txBox="1">
              <a:spLocks noChangeArrowheads="1"/>
            </p:cNvSpPr>
            <p:nvPr/>
          </p:nvSpPr>
          <p:spPr bwMode="auto">
            <a:xfrm rot="16200000">
              <a:off x="585128" y="4401508"/>
              <a:ext cx="76501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Grade 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" name="Text Box 12"/>
            <p:cNvSpPr txBox="1">
              <a:spLocks noChangeArrowheads="1"/>
            </p:cNvSpPr>
            <p:nvPr/>
          </p:nvSpPr>
          <p:spPr bwMode="auto">
            <a:xfrm rot="16200000">
              <a:off x="606913" y="5149398"/>
              <a:ext cx="69180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Grade 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" name="Text Box 12"/>
            <p:cNvSpPr txBox="1">
              <a:spLocks noChangeArrowheads="1"/>
            </p:cNvSpPr>
            <p:nvPr/>
          </p:nvSpPr>
          <p:spPr bwMode="auto">
            <a:xfrm rot="16200000">
              <a:off x="611038" y="5756324"/>
              <a:ext cx="70961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Grade 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422" name="Picture 11" descr="D:\Sumit\Breast manuscript HSP70-2\Manuscript HSP70-2 in breast\HSP70-2 paper Sumit\Breast cancer HSP70-2 2013\HSP70-2 in breast cancer\Latest 20X images 0ct14\20X\IDC PCNA HSP70-2 for grades\H&amp;E\grade 2 H&amp;E\329T Grade 2 H&amp;E 20X 5.jpg"/>
            <p:cNvPicPr>
              <a:picLocks noChangeAspect="1" noChangeArrowheads="1"/>
            </p:cNvPicPr>
            <p:nvPr/>
          </p:nvPicPr>
          <p:blipFill>
            <a:blip r:embed="rId7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1032964" y="4940971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23" name="Picture 2" descr="D:\Sumit\Breast manuscript HSP70-2\Manuscript HSP70-2 in breast\HSP70-2 paper Sumit\Breast cancer HSP70-2 2013\HSP70-2 in breast cancer\Latest 20X images 0ct14\20X\IDC PCNA HSP70-2 for grades\Control IgG\329T Grade 2 control IgG 20X 3.jpg"/>
            <p:cNvPicPr>
              <a:picLocks noChangeAspect="1" noChangeArrowheads="1"/>
            </p:cNvPicPr>
            <p:nvPr/>
          </p:nvPicPr>
          <p:blipFill>
            <a:blip r:embed="rId8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2817871" y="4940971"/>
              <a:ext cx="856751" cy="640080"/>
            </a:xfrm>
            <a:prstGeom prst="rect">
              <a:avLst/>
            </a:prstGeom>
            <a:noFill/>
          </p:spPr>
        </p:pic>
        <p:pic>
          <p:nvPicPr>
            <p:cNvPr id="424" name="Picture 3" descr="D:\Sumit\Breast manuscript HSP70-2\Manuscript HSP70-2 in breast\HSP70-2 paper Sumit\Breast cancer HSP70-2 2013\HSP70-2 in breast cancer\Latest 20X images 0ct14\20X\IDC PCNA HSP70-2 for grades\Control IgG\Grade 1 control IgG 20X 2.jpg"/>
            <p:cNvPicPr>
              <a:picLocks noChangeAspect="1" noChangeArrowheads="1"/>
            </p:cNvPicPr>
            <p:nvPr/>
          </p:nvPicPr>
          <p:blipFill>
            <a:blip r:embed="rId9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2814192" y="4260978"/>
              <a:ext cx="856752" cy="640080"/>
            </a:xfrm>
            <a:prstGeom prst="rect">
              <a:avLst/>
            </a:prstGeom>
            <a:noFill/>
          </p:spPr>
        </p:pic>
        <p:pic>
          <p:nvPicPr>
            <p:cNvPr id="425" name="Picture 4" descr="D:\Sumit\Breast manuscript HSP70-2\Manuscript HSP70-2 in breast\HSP70-2 paper Sumit\Breast cancer HSP70-2 2013\HSP70-2 in breast cancer\Latest 20X images 0ct14\20X\IDC PCNA HSP70-2 for grades\Control IgG\Grade 3 control IgG 20X 1.jpg"/>
            <p:cNvPicPr>
              <a:picLocks noChangeAspect="1" noChangeArrowheads="1"/>
            </p:cNvPicPr>
            <p:nvPr/>
          </p:nvPicPr>
          <p:blipFill>
            <a:blip r:embed="rId10" cstate="print">
              <a:lum bright="10000" contrast="10000"/>
            </a:blip>
            <a:srcRect/>
            <a:stretch>
              <a:fillRect/>
            </a:stretch>
          </p:blipFill>
          <p:spPr bwMode="auto">
            <a:xfrm>
              <a:off x="2805787" y="5624216"/>
              <a:ext cx="856751" cy="640080"/>
            </a:xfrm>
            <a:prstGeom prst="rect">
              <a:avLst/>
            </a:prstGeom>
            <a:noFill/>
          </p:spPr>
        </p:pic>
        <p:grpSp>
          <p:nvGrpSpPr>
            <p:cNvPr id="6" name="Group 278"/>
            <p:cNvGrpSpPr/>
            <p:nvPr/>
          </p:nvGrpSpPr>
          <p:grpSpPr>
            <a:xfrm>
              <a:off x="1275849" y="4064677"/>
              <a:ext cx="2396694" cy="219925"/>
              <a:chOff x="4814887" y="4136248"/>
              <a:chExt cx="2396694" cy="541396"/>
            </a:xfrm>
          </p:grpSpPr>
          <p:sp>
            <p:nvSpPr>
              <p:cNvPr id="427" name="Text Box 8"/>
              <p:cNvSpPr txBox="1">
                <a:spLocks noChangeArrowheads="1"/>
              </p:cNvSpPr>
              <p:nvPr/>
            </p:nvSpPr>
            <p:spPr bwMode="auto">
              <a:xfrm>
                <a:off x="4814887" y="4136248"/>
                <a:ext cx="618254" cy="5303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>
                  <a:spcBef>
                    <a:spcPct val="50000"/>
                  </a:spcBef>
                </a:pP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H&amp;E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9" name="Text Box 10"/>
              <p:cNvSpPr txBox="1">
                <a:spLocks noChangeArrowheads="1"/>
              </p:cNvSpPr>
              <p:nvPr/>
            </p:nvSpPr>
            <p:spPr bwMode="auto">
              <a:xfrm>
                <a:off x="5685483" y="4147279"/>
                <a:ext cx="658030" cy="5303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>
                  <a:spcBef>
                    <a:spcPct val="50000"/>
                  </a:spcBef>
                </a:pP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PCNA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0" name="Text Box 10"/>
              <p:cNvSpPr txBox="1">
                <a:spLocks noChangeArrowheads="1"/>
              </p:cNvSpPr>
              <p:nvPr/>
            </p:nvSpPr>
            <p:spPr bwMode="auto">
              <a:xfrm>
                <a:off x="6451424" y="4144849"/>
                <a:ext cx="760157" cy="5303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eaLnBrk="1" hangingPunct="1">
                  <a:spcBef>
                    <a:spcPct val="50000"/>
                  </a:spcBef>
                </a:pPr>
                <a:r>
                  <a:rPr lang="en-US" sz="800" dirty="0" smtClean="0">
                    <a:latin typeface="Arial" pitchFamily="34" charset="0"/>
                    <a:cs typeface="Arial" pitchFamily="34" charset="0"/>
                  </a:rPr>
                  <a:t>Control  </a:t>
                </a:r>
                <a:r>
                  <a:rPr lang="en-US" sz="800" dirty="0" err="1" smtClean="0">
                    <a:latin typeface="Arial" pitchFamily="34" charset="0"/>
                    <a:cs typeface="Arial" pitchFamily="34" charset="0"/>
                  </a:rPr>
                  <a:t>IgG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81" name="Group 80"/>
          <p:cNvGrpSpPr/>
          <p:nvPr/>
        </p:nvGrpSpPr>
        <p:grpSpPr>
          <a:xfrm>
            <a:off x="167091" y="320274"/>
            <a:ext cx="2891913" cy="2871791"/>
            <a:chOff x="309971" y="448866"/>
            <a:chExt cx="2891913" cy="2871791"/>
          </a:xfrm>
        </p:grpSpPr>
        <p:grpSp>
          <p:nvGrpSpPr>
            <p:cNvPr id="78" name="Group 77"/>
            <p:cNvGrpSpPr/>
            <p:nvPr/>
          </p:nvGrpSpPr>
          <p:grpSpPr>
            <a:xfrm>
              <a:off x="530707" y="448866"/>
              <a:ext cx="2671177" cy="2814340"/>
              <a:chOff x="968704" y="448866"/>
              <a:chExt cx="2671177" cy="2814340"/>
            </a:xfrm>
          </p:grpSpPr>
          <p:sp>
            <p:nvSpPr>
              <p:cNvPr id="20" name="Text Box 8"/>
              <p:cNvSpPr txBox="1">
                <a:spLocks noChangeArrowheads="1"/>
              </p:cNvSpPr>
              <p:nvPr/>
            </p:nvSpPr>
            <p:spPr bwMode="auto">
              <a:xfrm>
                <a:off x="1246930" y="448866"/>
                <a:ext cx="45686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altLang="en-US" sz="800" dirty="0">
                    <a:latin typeface="Arial" pitchFamily="34" charset="0"/>
                    <a:cs typeface="Arial" pitchFamily="34" charset="0"/>
                  </a:rPr>
                  <a:t>H&amp;E</a:t>
                </a:r>
              </a:p>
            </p:txBody>
          </p:sp>
          <p:sp>
            <p:nvSpPr>
              <p:cNvPr id="22" name="Text Box 10"/>
              <p:cNvSpPr txBox="1">
                <a:spLocks noChangeArrowheads="1"/>
              </p:cNvSpPr>
              <p:nvPr/>
            </p:nvSpPr>
            <p:spPr bwMode="auto">
              <a:xfrm>
                <a:off x="1956695" y="458391"/>
                <a:ext cx="8782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altLang="en-US" sz="800" dirty="0" smtClean="0">
                    <a:latin typeface="Arial" pitchFamily="34" charset="0"/>
                    <a:cs typeface="Arial" pitchFamily="34" charset="0"/>
                  </a:rPr>
                  <a:t>Control </a:t>
                </a:r>
                <a:r>
                  <a:rPr lang="en-US" altLang="en-US" sz="800" dirty="0" err="1" smtClean="0">
                    <a:latin typeface="Arial" pitchFamily="34" charset="0"/>
                    <a:cs typeface="Arial" pitchFamily="34" charset="0"/>
                  </a:rPr>
                  <a:t>IgG</a:t>
                </a:r>
                <a:endParaRPr lang="en-US" alt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" name="Text Box 8"/>
              <p:cNvSpPr txBox="1">
                <a:spLocks noChangeArrowheads="1"/>
              </p:cNvSpPr>
              <p:nvPr/>
            </p:nvSpPr>
            <p:spPr bwMode="auto">
              <a:xfrm>
                <a:off x="3036695" y="472982"/>
                <a:ext cx="561571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altLang="en-US" sz="800" dirty="0">
                    <a:latin typeface="Arial" pitchFamily="34" charset="0"/>
                    <a:cs typeface="Arial" pitchFamily="34" charset="0"/>
                  </a:rPr>
                  <a:t>ANCT</a:t>
                </a:r>
              </a:p>
            </p:txBody>
          </p:sp>
          <p:pic>
            <p:nvPicPr>
              <p:cNvPr id="2054" name="Picture 6" descr="C:\Users\Admin\Desktop\Breast cancer HSP70-2 20X\20X\PAtient data Breast cancer HSP70-2\DCIS\Control IgG\940T DCIS Ctrl IgG 20X 8.jpg"/>
              <p:cNvPicPr>
                <a:picLocks noChangeAspect="1" noChangeArrowheads="1"/>
              </p:cNvPicPr>
              <p:nvPr/>
            </p:nvPicPr>
            <p:blipFill>
              <a:blip r:embed="rId11" cstate="print"/>
              <a:srcRect/>
              <a:stretch>
                <a:fillRect/>
              </a:stretch>
            </p:blipFill>
            <p:spPr bwMode="auto">
              <a:xfrm>
                <a:off x="1855787" y="622353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5" name="Picture 7" descr="C:\Users\Admin\Desktop\Breast cancer HSP70-2 20X\20X\PAtient data Breast cancer HSP70-2\DCIS\H&amp;E\940T DCIS H&amp;E 20X 4.jpg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968704" y="612010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6" name="Picture 8" descr="C:\Users\Admin\Desktop\Breast cancer HSP70-2 20X\20X\PAtient data Breast cancer HSP70-2\DCIS + IDC\313T DCIS + IDC Ctrl IgG 20X 5.jpg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1885348" y="2619141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7" name="Picture 9" descr="C:\Users\Admin\Desktop\Breast cancer HSP70-2 20X\20X\PAtient data Breast cancer HSP70-2\DCIS + IDC\313T DCIS + IDC H&amp;E 20X 3.jpg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982129" y="262312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8" name="Picture 10" descr="C:\Users\Admin\Desktop\Breast cancer HSP70-2 20X\20X\PAtient data Breast cancer HSP70-2\ILC\HSP70-2 new\302T ILC H&amp;E 20X 10.jpg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987118" y="195738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9" name="Picture 11" descr="C:\Users\Admin\Desktop\Breast cancer HSP70-2 20X\20X\PAtient data Breast cancer HSP70-2\ILC\HSP70-2 new\302T ILC ctrl IgG 20X 3.jpg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1885769" y="1969887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0" name="Picture 12" descr="C:\Users\Admin\Desktop\Breast cancer HSP70-2 20X\20X\PAtient data Breast cancer HSP70-2\IDC stages\266T stage II ctrl IgG 20X 2.jpg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1866927" y="1299970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1" name="Picture 13" descr="C:\Users\Admin\Desktop\Breast cancer HSP70-2 20X\20X\PAtient data Breast cancer HSP70-2\IDC stages\266T stage II H&amp;E 20X 22.jpg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970428" y="128172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3074" name="Picture 2"/>
              <p:cNvPicPr>
                <a:picLocks noChangeAspect="1" noChangeArrowheads="1"/>
              </p:cNvPicPr>
              <p:nvPr/>
            </p:nvPicPr>
            <p:blipFill>
              <a:blip r:embed="rId19" cstate="print"/>
              <a:srcRect/>
              <a:stretch>
                <a:fillRect/>
              </a:stretch>
            </p:blipFill>
            <p:spPr bwMode="auto">
              <a:xfrm>
                <a:off x="2783129" y="2604627"/>
                <a:ext cx="856752" cy="6400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3075" name="Picture 3" descr="F:\HSP70-2 Breast cancer\ANCT\ANCT 19jan 2015 16.jpg"/>
              <p:cNvPicPr>
                <a:picLocks noChangeAspect="1" noChangeArrowheads="1"/>
              </p:cNvPicPr>
              <p:nvPr/>
            </p:nvPicPr>
            <p:blipFill>
              <a:blip r:embed="rId20" cstate="print"/>
              <a:srcRect/>
              <a:stretch>
                <a:fillRect/>
              </a:stretch>
            </p:blipFill>
            <p:spPr bwMode="auto">
              <a:xfrm>
                <a:off x="2783129" y="1944910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3076" name="Picture 4" descr="F:\HSP70-2 Breast cancer\ANCT\ANCT 19jan 2015 5.jpg"/>
              <p:cNvPicPr>
                <a:picLocks noChangeAspect="1" noChangeArrowheads="1"/>
              </p:cNvPicPr>
              <p:nvPr/>
            </p:nvPicPr>
            <p:blipFill>
              <a:blip r:embed="rId21" cstate="print"/>
              <a:srcRect/>
              <a:stretch>
                <a:fillRect/>
              </a:stretch>
            </p:blipFill>
            <p:spPr bwMode="auto">
              <a:xfrm>
                <a:off x="2753401" y="1270905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3077" name="Picture 5" descr="F:\HSP70-2 Breast cancer\ANCT\ANCT 19jan 2015 14.jpg"/>
              <p:cNvPicPr>
                <a:picLocks noChangeAspect="1" noChangeArrowheads="1"/>
              </p:cNvPicPr>
              <p:nvPr/>
            </p:nvPicPr>
            <p:blipFill>
              <a:blip r:embed="rId22" cstate="print"/>
              <a:srcRect/>
              <a:stretch>
                <a:fillRect/>
              </a:stretch>
            </p:blipFill>
            <p:spPr bwMode="auto">
              <a:xfrm>
                <a:off x="2753401" y="647780"/>
                <a:ext cx="856752" cy="640080"/>
              </a:xfrm>
              <a:prstGeom prst="rect">
                <a:avLst/>
              </a:prstGeom>
              <a:noFill/>
            </p:spPr>
          </p:pic>
        </p:grpSp>
        <p:grpSp>
          <p:nvGrpSpPr>
            <p:cNvPr id="72" name="Group 71"/>
            <p:cNvGrpSpPr/>
            <p:nvPr/>
          </p:nvGrpSpPr>
          <p:grpSpPr>
            <a:xfrm>
              <a:off x="309971" y="652488"/>
              <a:ext cx="245654" cy="2668169"/>
              <a:chOff x="-393699" y="1179536"/>
              <a:chExt cx="245654" cy="2668169"/>
            </a:xfrm>
          </p:grpSpPr>
          <p:sp>
            <p:nvSpPr>
              <p:cNvPr id="68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596543" y="1397202"/>
                <a:ext cx="66616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DCIS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69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24185" y="1882932"/>
                <a:ext cx="69180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IDC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20060" y="2525004"/>
                <a:ext cx="70961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ILC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82474" y="3314220"/>
                <a:ext cx="836139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DCIS+ IDC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82" name="Group 81"/>
          <p:cNvGrpSpPr/>
          <p:nvPr/>
        </p:nvGrpSpPr>
        <p:grpSpPr>
          <a:xfrm>
            <a:off x="3148413" y="322258"/>
            <a:ext cx="2866727" cy="2813686"/>
            <a:chOff x="3348445" y="450850"/>
            <a:chExt cx="2866727" cy="2813686"/>
          </a:xfrm>
        </p:grpSpPr>
        <p:grpSp>
          <p:nvGrpSpPr>
            <p:cNvPr id="77" name="Group 76"/>
            <p:cNvGrpSpPr/>
            <p:nvPr/>
          </p:nvGrpSpPr>
          <p:grpSpPr>
            <a:xfrm>
              <a:off x="3573446" y="450850"/>
              <a:ext cx="2641726" cy="2813686"/>
              <a:chOff x="5064257" y="450850"/>
              <a:chExt cx="2641726" cy="2813686"/>
            </a:xfrm>
          </p:grpSpPr>
          <p:pic>
            <p:nvPicPr>
              <p:cNvPr id="2050" name="Picture 2" descr="C:\Users\Admin\Desktop\Breast cancer HSP70-2 20X\20X\PAtient data Breast cancer HSP70-2\ANCT\ANCT 7.jpg"/>
              <p:cNvPicPr>
                <a:picLocks noChangeAspect="1" noChangeArrowheads="1"/>
              </p:cNvPicPr>
              <p:nvPr/>
            </p:nvPicPr>
            <p:blipFill>
              <a:blip r:embed="rId23" cstate="print"/>
              <a:srcRect/>
              <a:stretch>
                <a:fillRect/>
              </a:stretch>
            </p:blipFill>
            <p:spPr bwMode="auto">
              <a:xfrm>
                <a:off x="6843543" y="1963667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1" name="Picture 3" descr="C:\Users\Admin\Desktop\Breast cancer HSP70-2 20X\20X\PAtient data Breast cancer HSP70-2\ANCT\ANCT 1.jpg"/>
              <p:cNvPicPr>
                <a:picLocks noChangeAspect="1" noChangeArrowheads="1"/>
              </p:cNvPicPr>
              <p:nvPr/>
            </p:nvPicPr>
            <p:blipFill>
              <a:blip r:embed="rId24" cstate="print"/>
              <a:srcRect/>
              <a:stretch>
                <a:fillRect/>
              </a:stretch>
            </p:blipFill>
            <p:spPr bwMode="auto">
              <a:xfrm>
                <a:off x="6843543" y="645939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2" name="Picture 4" descr="C:\Users\Admin\Desktop\Breast cancer HSP70-2 20X\20X\PAtient data Breast cancer HSP70-2\ANCT\ANCT 2.jpg"/>
              <p:cNvPicPr>
                <a:picLocks noChangeAspect="1" noChangeArrowheads="1"/>
              </p:cNvPicPr>
              <p:nvPr/>
            </p:nvPicPr>
            <p:blipFill>
              <a:blip r:embed="rId25" cstate="print"/>
              <a:srcRect/>
              <a:stretch>
                <a:fillRect/>
              </a:stretch>
            </p:blipFill>
            <p:spPr bwMode="auto">
              <a:xfrm>
                <a:off x="6843543" y="262445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53" name="Picture 5" descr="C:\Users\Admin\Desktop\Breast cancer HSP70-2 20X\20X\PAtient data Breast cancer HSP70-2\ANCT\ANCT 4.jpg"/>
              <p:cNvPicPr>
                <a:picLocks noChangeAspect="1" noChangeArrowheads="1"/>
              </p:cNvPicPr>
              <p:nvPr/>
            </p:nvPicPr>
            <p:blipFill>
              <a:blip r:embed="rId26" cstate="print"/>
              <a:srcRect/>
              <a:stretch>
                <a:fillRect/>
              </a:stretch>
            </p:blipFill>
            <p:spPr bwMode="auto">
              <a:xfrm>
                <a:off x="6849231" y="1302467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400" name="Picture 12" descr="C:\Users\Admin\Desktop\Breast cancer HSP70-2 20X\20X\PAtient data Breast cancer HSP70-2\IDC stages\266T stage II ctrl IgG 20X 2.jpg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5961776" y="1301661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401" name="Picture 13" descr="C:\Users\Admin\Desktop\Breast cancer HSP70-2 20X\20X\PAtient data Breast cancer HSP70-2\IDC stages\266T stage II H&amp;E 20X 22.jpg"/>
              <p:cNvPicPr>
                <a:picLocks noChangeAspect="1" noChangeArrowheads="1"/>
              </p:cNvPicPr>
              <p:nvPr/>
            </p:nvPicPr>
            <p:blipFill>
              <a:blip r:embed="rId18" cstate="print"/>
              <a:srcRect/>
              <a:stretch>
                <a:fillRect/>
              </a:stretch>
            </p:blipFill>
            <p:spPr bwMode="auto">
              <a:xfrm>
                <a:off x="5064257" y="1292942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2" name="Picture 14" descr="C:\Users\Admin\Desktop\Breast cancer HSP70-2 20X\20X\PAtient data Breast cancer HSP70-2\IDC stages\466T stage III ctrl IgG 20X 6.jpg"/>
              <p:cNvPicPr>
                <a:picLocks noChangeAspect="1" noChangeArrowheads="1"/>
              </p:cNvPicPr>
              <p:nvPr/>
            </p:nvPicPr>
            <p:blipFill>
              <a:blip r:embed="rId27" cstate="print"/>
              <a:srcRect/>
              <a:stretch>
                <a:fillRect/>
              </a:stretch>
            </p:blipFill>
            <p:spPr bwMode="auto">
              <a:xfrm>
                <a:off x="5961661" y="195306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3" name="Picture 15" descr="C:\Users\Admin\Desktop\Breast cancer HSP70-2 20X\20X\PAtient data Breast cancer HSP70-2\IDC stages\466T stage III H&amp;E 20X 4.jpg"/>
              <p:cNvPicPr>
                <a:picLocks noChangeAspect="1" noChangeArrowheads="1"/>
              </p:cNvPicPr>
              <p:nvPr/>
            </p:nvPicPr>
            <p:blipFill>
              <a:blip r:embed="rId28" cstate="print"/>
              <a:srcRect/>
              <a:stretch>
                <a:fillRect/>
              </a:stretch>
            </p:blipFill>
            <p:spPr bwMode="auto">
              <a:xfrm>
                <a:off x="5064257" y="1953617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4" name="Picture 16" descr="C:\Users\Admin\Desktop\Breast cancer HSP70-2 20X\20X\PAtient data Breast cancer HSP70-2\IDC stages\750TB stage IV H&amp;E 20X 12.jpg"/>
              <p:cNvPicPr>
                <a:picLocks noChangeAspect="1" noChangeArrowheads="1"/>
              </p:cNvPicPr>
              <p:nvPr/>
            </p:nvPicPr>
            <p:blipFill>
              <a:blip r:embed="rId29" cstate="print"/>
              <a:srcRect/>
              <a:stretch>
                <a:fillRect/>
              </a:stretch>
            </p:blipFill>
            <p:spPr bwMode="auto">
              <a:xfrm>
                <a:off x="5064257" y="262445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5" name="Picture 17" descr="C:\Users\Admin\Desktop\Breast cancer HSP70-2 20X\20X\PAtient data Breast cancer HSP70-2\IDC stages\750TB stage IV ctrl IgG 20X 12.jpg"/>
              <p:cNvPicPr>
                <a:picLocks noChangeAspect="1" noChangeArrowheads="1"/>
              </p:cNvPicPr>
              <p:nvPr/>
            </p:nvPicPr>
            <p:blipFill>
              <a:blip r:embed="rId30" cstate="print"/>
              <a:srcRect/>
              <a:stretch>
                <a:fillRect/>
              </a:stretch>
            </p:blipFill>
            <p:spPr bwMode="auto">
              <a:xfrm>
                <a:off x="5961661" y="262445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6" name="Picture 18" descr="C:\Users\Admin\Desktop\Breast cancer HSP70-2 20X\20X\PAtient data Breast cancer HSP70-2\IDC stages\1051T stage I H&amp;E 20X 2.jpg"/>
              <p:cNvPicPr>
                <a:picLocks noChangeAspect="1" noChangeArrowheads="1"/>
              </p:cNvPicPr>
              <p:nvPr/>
            </p:nvPicPr>
            <p:blipFill>
              <a:blip r:embed="rId31" cstate="print"/>
              <a:srcRect/>
              <a:stretch>
                <a:fillRect/>
              </a:stretch>
            </p:blipFill>
            <p:spPr bwMode="auto">
              <a:xfrm>
                <a:off x="5065554" y="635596"/>
                <a:ext cx="856752" cy="640080"/>
              </a:xfrm>
              <a:prstGeom prst="rect">
                <a:avLst/>
              </a:prstGeom>
              <a:noFill/>
            </p:spPr>
          </p:pic>
          <p:pic>
            <p:nvPicPr>
              <p:cNvPr id="2067" name="Picture 19" descr="C:\Users\Admin\Desktop\Breast cancer HSP70-2 20X\20X\PAtient data Breast cancer HSP70-2\IDC stages\1051T stage I ctrl IgG 20X 5.jpg"/>
              <p:cNvPicPr>
                <a:picLocks noChangeAspect="1" noChangeArrowheads="1"/>
              </p:cNvPicPr>
              <p:nvPr/>
            </p:nvPicPr>
            <p:blipFill>
              <a:blip r:embed="rId32" cstate="print"/>
              <a:srcRect/>
              <a:stretch>
                <a:fillRect/>
              </a:stretch>
            </p:blipFill>
            <p:spPr bwMode="auto">
              <a:xfrm>
                <a:off x="5962447" y="629113"/>
                <a:ext cx="856752" cy="640080"/>
              </a:xfrm>
              <a:prstGeom prst="rect">
                <a:avLst/>
              </a:prstGeom>
              <a:noFill/>
            </p:spPr>
          </p:pic>
          <p:grpSp>
            <p:nvGrpSpPr>
              <p:cNvPr id="7" name="Group 67"/>
              <p:cNvGrpSpPr/>
              <p:nvPr/>
            </p:nvGrpSpPr>
            <p:grpSpPr>
              <a:xfrm>
                <a:off x="5310951" y="450850"/>
                <a:ext cx="2337615" cy="239560"/>
                <a:chOff x="5263326" y="69850"/>
                <a:chExt cx="2337615" cy="239560"/>
              </a:xfrm>
            </p:grpSpPr>
            <p:sp>
              <p:nvSpPr>
                <p:cNvPr id="65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5263326" y="69850"/>
                  <a:ext cx="456867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</a:pPr>
                  <a:r>
                    <a:rPr lang="en-US" altLang="en-US" sz="800" dirty="0">
                      <a:latin typeface="Arial" pitchFamily="34" charset="0"/>
                      <a:cs typeface="Arial" pitchFamily="34" charset="0"/>
                    </a:rPr>
                    <a:t>H&amp;E</a:t>
                  </a:r>
                </a:p>
              </p:txBody>
            </p:sp>
            <p:sp>
              <p:nvSpPr>
                <p:cNvPr id="66" name="Text Box 10"/>
                <p:cNvSpPr txBox="1">
                  <a:spLocks noChangeArrowheads="1"/>
                </p:cNvSpPr>
                <p:nvPr/>
              </p:nvSpPr>
              <p:spPr bwMode="auto">
                <a:xfrm>
                  <a:off x="6002234" y="79375"/>
                  <a:ext cx="878237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</a:pPr>
                  <a:r>
                    <a:rPr lang="en-US" altLang="en-US" sz="800" dirty="0" smtClean="0">
                      <a:latin typeface="Arial" pitchFamily="34" charset="0"/>
                      <a:cs typeface="Arial" pitchFamily="34" charset="0"/>
                    </a:rPr>
                    <a:t>Control </a:t>
                  </a:r>
                  <a:r>
                    <a:rPr lang="en-US" altLang="en-US" sz="800" dirty="0" err="1" smtClean="0">
                      <a:latin typeface="Arial" pitchFamily="34" charset="0"/>
                      <a:cs typeface="Arial" pitchFamily="34" charset="0"/>
                    </a:rPr>
                    <a:t>IgG</a:t>
                  </a:r>
                  <a:endParaRPr lang="en-US" altLang="en-US" sz="8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7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7039370" y="93966"/>
                  <a:ext cx="561571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charset="0"/>
                    </a:defRPr>
                  </a:lvl9pPr>
                </a:lstStyle>
                <a:p>
                  <a:pPr eaLnBrk="1" hangingPunct="1">
                    <a:spcBef>
                      <a:spcPct val="50000"/>
                    </a:spcBef>
                  </a:pPr>
                  <a:r>
                    <a:rPr lang="en-US" altLang="en-US" sz="800" dirty="0">
                      <a:latin typeface="Arial" pitchFamily="34" charset="0"/>
                      <a:cs typeface="Arial" pitchFamily="34" charset="0"/>
                    </a:rPr>
                    <a:t>ANCT</a:t>
                  </a:r>
                </a:p>
              </p:txBody>
            </p:sp>
          </p:grpSp>
        </p:grpSp>
        <p:grpSp>
          <p:nvGrpSpPr>
            <p:cNvPr id="80" name="Group 79"/>
            <p:cNvGrpSpPr/>
            <p:nvPr/>
          </p:nvGrpSpPr>
          <p:grpSpPr>
            <a:xfrm>
              <a:off x="3348445" y="654050"/>
              <a:ext cx="245654" cy="2564981"/>
              <a:chOff x="-393699" y="3264294"/>
              <a:chExt cx="245654" cy="2564981"/>
            </a:xfrm>
          </p:grpSpPr>
          <p:sp>
            <p:nvSpPr>
              <p:cNvPr id="73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596543" y="3481960"/>
                <a:ext cx="66616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Stage I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4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24185" y="4067706"/>
                <a:ext cx="69180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Stage II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20060" y="4730822"/>
                <a:ext cx="70961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Stage III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" name="Text Box 12"/>
              <p:cNvSpPr txBox="1">
                <a:spLocks noChangeArrowheads="1"/>
              </p:cNvSpPr>
              <p:nvPr/>
            </p:nvSpPr>
            <p:spPr bwMode="auto">
              <a:xfrm rot="16200000">
                <a:off x="-619210" y="5359053"/>
                <a:ext cx="709613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>
                  <a:spcBef>
                    <a:spcPct val="50000"/>
                  </a:spcBef>
                </a:pPr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Stage IV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83" name="TextBox 199"/>
          <p:cNvSpPr txBox="1">
            <a:spLocks noChangeArrowheads="1"/>
          </p:cNvSpPr>
          <p:nvPr/>
        </p:nvSpPr>
        <p:spPr bwMode="auto">
          <a:xfrm>
            <a:off x="3001951" y="274568"/>
            <a:ext cx="26321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86" name="Group 385"/>
          <p:cNvGrpSpPr/>
          <p:nvPr/>
        </p:nvGrpSpPr>
        <p:grpSpPr>
          <a:xfrm>
            <a:off x="508447" y="3291784"/>
            <a:ext cx="3558024" cy="3442384"/>
            <a:chOff x="508447" y="3163192"/>
            <a:chExt cx="3558024" cy="3442384"/>
          </a:xfrm>
        </p:grpSpPr>
        <p:grpSp>
          <p:nvGrpSpPr>
            <p:cNvPr id="84" name="Group 238"/>
            <p:cNvGrpSpPr/>
            <p:nvPr/>
          </p:nvGrpSpPr>
          <p:grpSpPr>
            <a:xfrm>
              <a:off x="1706286" y="3163192"/>
              <a:ext cx="989315" cy="1462698"/>
              <a:chOff x="7177561" y="1243076"/>
              <a:chExt cx="1319086" cy="1363889"/>
            </a:xfrm>
          </p:grpSpPr>
          <p:grpSp>
            <p:nvGrpSpPr>
              <p:cNvPr id="85" name="Group 228"/>
              <p:cNvGrpSpPr/>
              <p:nvPr/>
            </p:nvGrpSpPr>
            <p:grpSpPr>
              <a:xfrm>
                <a:off x="7264508" y="1243076"/>
                <a:ext cx="1232139" cy="1363193"/>
                <a:chOff x="7264508" y="1243076"/>
                <a:chExt cx="1232139" cy="1363193"/>
              </a:xfrm>
            </p:grpSpPr>
            <p:grpSp>
              <p:nvGrpSpPr>
                <p:cNvPr id="90" name="Group 115"/>
                <p:cNvGrpSpPr/>
                <p:nvPr/>
              </p:nvGrpSpPr>
              <p:grpSpPr>
                <a:xfrm>
                  <a:off x="7264508" y="1243076"/>
                  <a:ext cx="1232139" cy="1363193"/>
                  <a:chOff x="6243068" y="1174980"/>
                  <a:chExt cx="1232139" cy="1363193"/>
                </a:xfrm>
              </p:grpSpPr>
              <p:grpSp>
                <p:nvGrpSpPr>
                  <p:cNvPr id="93" name="Group 99"/>
                  <p:cNvGrpSpPr/>
                  <p:nvPr/>
                </p:nvGrpSpPr>
                <p:grpSpPr>
                  <a:xfrm>
                    <a:off x="6582248" y="1242690"/>
                    <a:ext cx="892959" cy="1295483"/>
                    <a:chOff x="6677250" y="1273655"/>
                    <a:chExt cx="1131580" cy="2184482"/>
                  </a:xfrm>
                </p:grpSpPr>
                <p:grpSp>
                  <p:nvGrpSpPr>
                    <p:cNvPr id="104" name="Group 98"/>
                    <p:cNvGrpSpPr/>
                    <p:nvPr/>
                  </p:nvGrpSpPr>
                  <p:grpSpPr>
                    <a:xfrm>
                      <a:off x="6677250" y="1273655"/>
                      <a:ext cx="1131580" cy="2184482"/>
                      <a:chOff x="6677250" y="749780"/>
                      <a:chExt cx="1131580" cy="2184482"/>
                    </a:xfrm>
                  </p:grpSpPr>
                  <p:grpSp>
                    <p:nvGrpSpPr>
                      <p:cNvPr id="107" name="Group 55"/>
                      <p:cNvGrpSpPr/>
                      <p:nvPr/>
                    </p:nvGrpSpPr>
                    <p:grpSpPr>
                      <a:xfrm>
                        <a:off x="6677250" y="749780"/>
                        <a:ext cx="1005840" cy="1828800"/>
                        <a:chOff x="1662446" y="1217592"/>
                        <a:chExt cx="1005840" cy="1828800"/>
                      </a:xfrm>
                    </p:grpSpPr>
                    <p:cxnSp>
                      <p:nvCxnSpPr>
                        <p:cNvPr id="109" name="Straight Connector 56"/>
                        <p:cNvCxnSpPr/>
                        <p:nvPr/>
                      </p:nvCxnSpPr>
                      <p:spPr>
                        <a:xfrm rot="5400000">
                          <a:off x="799394" y="2131991"/>
                          <a:ext cx="1828800" cy="1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10" name="Straight Connector 109"/>
                        <p:cNvCxnSpPr/>
                        <p:nvPr/>
                      </p:nvCxnSpPr>
                      <p:spPr>
                        <a:xfrm rot="10800000">
                          <a:off x="1662446" y="2991693"/>
                          <a:ext cx="1005840" cy="1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11" name="Rectangle 110"/>
                        <p:cNvSpPr/>
                        <p:nvPr/>
                      </p:nvSpPr>
                      <p:spPr>
                        <a:xfrm>
                          <a:off x="1919831" y="1950211"/>
                          <a:ext cx="182879" cy="1048484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112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1958406" y="1935928"/>
                          <a:ext cx="107932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13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945942" y="1876887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14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952293" y="1990229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sp>
                      <p:nvSpPr>
                        <p:cNvPr id="115" name="Rectangle 114"/>
                        <p:cNvSpPr/>
                        <p:nvPr/>
                      </p:nvSpPr>
                      <p:spPr>
                        <a:xfrm>
                          <a:off x="2370042" y="1898685"/>
                          <a:ext cx="182879" cy="1094741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116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2392966" y="1902188"/>
                          <a:ext cx="138770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17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401571" y="1826948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18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402272" y="1978673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19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9574" y="1241844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0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7380" y="1413700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1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15936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2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176892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3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194418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4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211563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5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29089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6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24699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7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64522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28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81667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</p:grpSp>
                  <p:sp>
                    <p:nvSpPr>
                      <p:cNvPr id="108" name="TextBox 107"/>
                      <p:cNvSpPr txBox="1"/>
                      <p:nvPr/>
                    </p:nvSpPr>
                    <p:spPr>
                      <a:xfrm>
                        <a:off x="7112207" y="2467178"/>
                        <a:ext cx="696623" cy="467084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Late</a:t>
                        </a:r>
                      </a:p>
                      <a:p>
                        <a:pPr algn="ctr"/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stages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cxnSp>
                  <p:nvCxnSpPr>
                    <p:cNvPr id="105" name="Straight Connector 104"/>
                    <p:cNvCxnSpPr/>
                    <p:nvPr/>
                  </p:nvCxnSpPr>
                  <p:spPr bwMode="auto">
                    <a:xfrm rot="5400000">
                      <a:off x="7193800" y="3067920"/>
                      <a:ext cx="46493" cy="158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6" name="Straight Connector 105"/>
                    <p:cNvCxnSpPr/>
                    <p:nvPr/>
                  </p:nvCxnSpPr>
                  <p:spPr bwMode="auto">
                    <a:xfrm rot="5400000">
                      <a:off x="7656613" y="3070613"/>
                      <a:ext cx="46493" cy="158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94" name="TextBox 93"/>
                  <p:cNvSpPr txBox="1"/>
                  <p:nvPr/>
                </p:nvSpPr>
                <p:spPr>
                  <a:xfrm>
                    <a:off x="6287849" y="2105734"/>
                    <a:ext cx="361637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1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5" name="TextBox 94"/>
                  <p:cNvSpPr txBox="1"/>
                  <p:nvPr/>
                </p:nvSpPr>
                <p:spPr>
                  <a:xfrm>
                    <a:off x="6287847" y="2002758"/>
                    <a:ext cx="42817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2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6" name="TextBox 95"/>
                  <p:cNvSpPr txBox="1"/>
                  <p:nvPr/>
                </p:nvSpPr>
                <p:spPr>
                  <a:xfrm>
                    <a:off x="6288249" y="1899604"/>
                    <a:ext cx="52302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3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7" name="TextBox 96"/>
                  <p:cNvSpPr txBox="1"/>
                  <p:nvPr/>
                </p:nvSpPr>
                <p:spPr>
                  <a:xfrm>
                    <a:off x="6288687" y="1794175"/>
                    <a:ext cx="52258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4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8" name="TextBox 97"/>
                  <p:cNvSpPr txBox="1"/>
                  <p:nvPr/>
                </p:nvSpPr>
                <p:spPr>
                  <a:xfrm>
                    <a:off x="6288684" y="1691775"/>
                    <a:ext cx="52258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5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99" name="TextBox 98"/>
                  <p:cNvSpPr txBox="1"/>
                  <p:nvPr/>
                </p:nvSpPr>
                <p:spPr>
                  <a:xfrm>
                    <a:off x="6288209" y="1582728"/>
                    <a:ext cx="523063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6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0" name="TextBox 99"/>
                  <p:cNvSpPr txBox="1"/>
                  <p:nvPr/>
                </p:nvSpPr>
                <p:spPr>
                  <a:xfrm>
                    <a:off x="6287735" y="1482452"/>
                    <a:ext cx="618789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7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1" name="TextBox 100"/>
                  <p:cNvSpPr txBox="1"/>
                  <p:nvPr/>
                </p:nvSpPr>
                <p:spPr>
                  <a:xfrm>
                    <a:off x="6286783" y="1382176"/>
                    <a:ext cx="619741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8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2" name="TextBox 101"/>
                  <p:cNvSpPr txBox="1"/>
                  <p:nvPr/>
                </p:nvSpPr>
                <p:spPr>
                  <a:xfrm>
                    <a:off x="6285833" y="1278574"/>
                    <a:ext cx="52544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9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103" name="TextBox 102"/>
                  <p:cNvSpPr txBox="1"/>
                  <p:nvPr/>
                </p:nvSpPr>
                <p:spPr>
                  <a:xfrm>
                    <a:off x="6243068" y="1174980"/>
                    <a:ext cx="568204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10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91" name="TextBox 90"/>
                <p:cNvSpPr txBox="1"/>
                <p:nvPr/>
              </p:nvSpPr>
              <p:spPr>
                <a:xfrm>
                  <a:off x="8015786" y="1528394"/>
                  <a:ext cx="4791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45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7671625" y="1558812"/>
                  <a:ext cx="4791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71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86" name="TextBox 85"/>
              <p:cNvSpPr txBox="1"/>
              <p:nvPr/>
            </p:nvSpPr>
            <p:spPr>
              <a:xfrm>
                <a:off x="7382075" y="2265726"/>
                <a:ext cx="30393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7597858" y="2329966"/>
                <a:ext cx="5497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Early</a:t>
                </a:r>
              </a:p>
              <a:p>
                <a:pPr algn="ctr"/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stages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 rot="16200000">
                <a:off x="7155670" y="1761446"/>
                <a:ext cx="351557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IRS</a:t>
                </a:r>
                <a:endParaRPr lang="en-IN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29" name="Group 239"/>
            <p:cNvGrpSpPr/>
            <p:nvPr/>
          </p:nvGrpSpPr>
          <p:grpSpPr>
            <a:xfrm>
              <a:off x="1646962" y="4853346"/>
              <a:ext cx="1087900" cy="1386823"/>
              <a:chOff x="1866417" y="4655747"/>
              <a:chExt cx="1450531" cy="1386823"/>
            </a:xfrm>
          </p:grpSpPr>
          <p:grpSp>
            <p:nvGrpSpPr>
              <p:cNvPr id="130" name="Group 230"/>
              <p:cNvGrpSpPr/>
              <p:nvPr/>
            </p:nvGrpSpPr>
            <p:grpSpPr>
              <a:xfrm>
                <a:off x="1959972" y="4655747"/>
                <a:ext cx="1356976" cy="1386823"/>
                <a:chOff x="1959972" y="4655747"/>
                <a:chExt cx="1356976" cy="1386823"/>
              </a:xfrm>
            </p:grpSpPr>
            <p:grpSp>
              <p:nvGrpSpPr>
                <p:cNvPr id="133" name="Group 163"/>
                <p:cNvGrpSpPr/>
                <p:nvPr/>
              </p:nvGrpSpPr>
              <p:grpSpPr>
                <a:xfrm>
                  <a:off x="1959972" y="4655747"/>
                  <a:ext cx="1356976" cy="1386823"/>
                  <a:chOff x="1959972" y="4655747"/>
                  <a:chExt cx="1356976" cy="1386823"/>
                </a:xfrm>
              </p:grpSpPr>
              <p:grpSp>
                <p:nvGrpSpPr>
                  <p:cNvPr id="137" name="Group 159"/>
                  <p:cNvGrpSpPr/>
                  <p:nvPr/>
                </p:nvGrpSpPr>
                <p:grpSpPr>
                  <a:xfrm>
                    <a:off x="1959972" y="4655747"/>
                    <a:ext cx="1275248" cy="1386823"/>
                    <a:chOff x="4424280" y="5048939"/>
                    <a:chExt cx="1275248" cy="1386823"/>
                  </a:xfrm>
                </p:grpSpPr>
                <p:grpSp>
                  <p:nvGrpSpPr>
                    <p:cNvPr id="140" name="Group 116"/>
                    <p:cNvGrpSpPr/>
                    <p:nvPr/>
                  </p:nvGrpSpPr>
                  <p:grpSpPr>
                    <a:xfrm>
                      <a:off x="4424280" y="5048939"/>
                      <a:ext cx="1275248" cy="1386823"/>
                      <a:chOff x="1987158" y="1124848"/>
                      <a:chExt cx="1591590" cy="2179508"/>
                    </a:xfrm>
                  </p:grpSpPr>
                  <p:grpSp>
                    <p:nvGrpSpPr>
                      <p:cNvPr id="145" name="Group 54"/>
                      <p:cNvGrpSpPr/>
                      <p:nvPr/>
                    </p:nvGrpSpPr>
                    <p:grpSpPr>
                      <a:xfrm>
                        <a:off x="1987158" y="1124848"/>
                        <a:ext cx="1591590" cy="2179508"/>
                        <a:chOff x="1234683" y="1077223"/>
                        <a:chExt cx="1591590" cy="2179508"/>
                      </a:xfrm>
                    </p:grpSpPr>
                    <p:cxnSp>
                      <p:nvCxnSpPr>
                        <p:cNvPr id="148" name="Straight Connector 147"/>
                        <p:cNvCxnSpPr/>
                        <p:nvPr/>
                      </p:nvCxnSpPr>
                      <p:spPr>
                        <a:xfrm rot="5400000">
                          <a:off x="799394" y="2131991"/>
                          <a:ext cx="1828800" cy="1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149" name="Straight Connector 148"/>
                        <p:cNvCxnSpPr/>
                        <p:nvPr/>
                      </p:nvCxnSpPr>
                      <p:spPr>
                        <a:xfrm rot="10800000">
                          <a:off x="1662228" y="2991694"/>
                          <a:ext cx="1164045" cy="2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150" name="Rectangle 149"/>
                        <p:cNvSpPr/>
                        <p:nvPr/>
                      </p:nvSpPr>
                      <p:spPr>
                        <a:xfrm>
                          <a:off x="1817121" y="2079928"/>
                          <a:ext cx="182880" cy="919717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151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1809070" y="2053350"/>
                          <a:ext cx="201187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2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848884" y="1947430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3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849584" y="2163212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sp>
                      <p:nvSpPr>
                        <p:cNvPr id="154" name="Rectangle 153"/>
                        <p:cNvSpPr/>
                        <p:nvPr/>
                      </p:nvSpPr>
                      <p:spPr>
                        <a:xfrm>
                          <a:off x="2148155" y="1916659"/>
                          <a:ext cx="182880" cy="1077789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155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2180131" y="1896995"/>
                          <a:ext cx="129335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6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184018" y="1832591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7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184718" y="1962560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8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9574" y="1223419"/>
                          <a:ext cx="48006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59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7380" y="1413700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0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15936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1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176892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2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194418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3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211563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4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29089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5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24699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6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64522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167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81667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sp>
                      <p:nvSpPr>
                        <p:cNvPr id="168" name="TextBox 167"/>
                        <p:cNvSpPr txBox="1"/>
                        <p:nvPr/>
                      </p:nvSpPr>
                      <p:spPr>
                        <a:xfrm>
                          <a:off x="1282003" y="2682885"/>
                          <a:ext cx="451343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1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69" name="TextBox 168"/>
                        <p:cNvSpPr txBox="1"/>
                        <p:nvPr/>
                      </p:nvSpPr>
                      <p:spPr>
                        <a:xfrm>
                          <a:off x="1281999" y="2495045"/>
                          <a:ext cx="487011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2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0" name="TextBox 169"/>
                        <p:cNvSpPr txBox="1"/>
                        <p:nvPr/>
                      </p:nvSpPr>
                      <p:spPr>
                        <a:xfrm>
                          <a:off x="1282592" y="2323055"/>
                          <a:ext cx="486417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3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1" name="TextBox 170"/>
                        <p:cNvSpPr txBox="1"/>
                        <p:nvPr/>
                      </p:nvSpPr>
                      <p:spPr>
                        <a:xfrm>
                          <a:off x="1282592" y="2141003"/>
                          <a:ext cx="605296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4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2" name="TextBox 171"/>
                        <p:cNvSpPr txBox="1"/>
                        <p:nvPr/>
                      </p:nvSpPr>
                      <p:spPr>
                        <a:xfrm>
                          <a:off x="1282588" y="1969623"/>
                          <a:ext cx="605300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5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3" name="TextBox 172"/>
                        <p:cNvSpPr txBox="1"/>
                        <p:nvPr/>
                      </p:nvSpPr>
                      <p:spPr>
                        <a:xfrm>
                          <a:off x="1281996" y="1793021"/>
                          <a:ext cx="724770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6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4" name="TextBox 173"/>
                        <p:cNvSpPr txBox="1"/>
                        <p:nvPr/>
                      </p:nvSpPr>
                      <p:spPr>
                        <a:xfrm>
                          <a:off x="1281403" y="1624979"/>
                          <a:ext cx="606484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7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5" name="TextBox 174"/>
                        <p:cNvSpPr txBox="1"/>
                        <p:nvPr/>
                      </p:nvSpPr>
                      <p:spPr>
                        <a:xfrm>
                          <a:off x="1284362" y="1441259"/>
                          <a:ext cx="722402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8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6" name="TextBox 175"/>
                        <p:cNvSpPr txBox="1"/>
                        <p:nvPr/>
                      </p:nvSpPr>
                      <p:spPr>
                        <a:xfrm>
                          <a:off x="1283177" y="1262764"/>
                          <a:ext cx="604709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9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7" name="TextBox 176"/>
                        <p:cNvSpPr txBox="1"/>
                        <p:nvPr/>
                      </p:nvSpPr>
                      <p:spPr>
                        <a:xfrm>
                          <a:off x="1234683" y="1077223"/>
                          <a:ext cx="653204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100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8" name="TextBox 177"/>
                        <p:cNvSpPr txBox="1"/>
                        <p:nvPr/>
                      </p:nvSpPr>
                      <p:spPr>
                        <a:xfrm>
                          <a:off x="1686854" y="2965833"/>
                          <a:ext cx="614063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DCIS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sp>
                      <p:nvSpPr>
                        <p:cNvPr id="179" name="TextBox 178"/>
                        <p:cNvSpPr txBox="1"/>
                        <p:nvPr/>
                      </p:nvSpPr>
                      <p:spPr>
                        <a:xfrm>
                          <a:off x="2050404" y="2966513"/>
                          <a:ext cx="528702" cy="29021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600" dirty="0" smtClean="0">
                              <a:latin typeface="Arial" pitchFamily="34" charset="0"/>
                              <a:cs typeface="Arial" pitchFamily="34" charset="0"/>
                            </a:rPr>
                            <a:t>IDC</a:t>
                          </a:r>
                          <a:endParaRPr lang="en-US" sz="600" dirty="0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</p:grpSp>
                  <p:cxnSp>
                    <p:nvCxnSpPr>
                      <p:cNvPr id="146" name="Straight Connector 145"/>
                      <p:cNvCxnSpPr/>
                      <p:nvPr/>
                    </p:nvCxnSpPr>
                    <p:spPr bwMode="auto">
                      <a:xfrm rot="5400000">
                        <a:off x="2796672" y="3067243"/>
                        <a:ext cx="71853" cy="1588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147" name="Straight Connector 146"/>
                      <p:cNvCxnSpPr/>
                      <p:nvPr/>
                    </p:nvCxnSpPr>
                    <p:spPr bwMode="auto">
                      <a:xfrm rot="5400000">
                        <a:off x="3538687" y="3069936"/>
                        <a:ext cx="71853" cy="1588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141" name="Rectangle 140"/>
                    <p:cNvSpPr/>
                    <p:nvPr/>
                  </p:nvSpPr>
                  <p:spPr>
                    <a:xfrm>
                      <a:off x="5450335" y="5648605"/>
                      <a:ext cx="146532" cy="621792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42" name="Straight Connector 114"/>
                    <p:cNvCxnSpPr>
                      <a:cxnSpLocks noChangeShapeType="1"/>
                    </p:cNvCxnSpPr>
                    <p:nvPr/>
                  </p:nvCxnSpPr>
                  <p:spPr bwMode="auto">
                    <a:xfrm rot="5400000">
                      <a:off x="5413470" y="5613059"/>
                      <a:ext cx="228600" cy="1695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  <p:cxnSp>
                  <p:nvCxnSpPr>
                    <p:cNvPr id="143" name="Straight Connector 115"/>
                    <p:cNvCxnSpPr>
                      <a:cxnSpLocks noChangeShapeType="1"/>
                    </p:cNvCxnSpPr>
                    <p:nvPr/>
                  </p:nvCxnSpPr>
                  <p:spPr bwMode="auto">
                    <a:xfrm>
                      <a:off x="5479070" y="5498437"/>
                      <a:ext cx="97588" cy="1010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  <p:cxnSp>
                  <p:nvCxnSpPr>
                    <p:cNvPr id="144" name="Straight Connector 115"/>
                    <p:cNvCxnSpPr>
                      <a:cxnSpLocks noChangeShapeType="1"/>
                    </p:cNvCxnSpPr>
                    <p:nvPr/>
                  </p:nvCxnSpPr>
                  <p:spPr bwMode="auto">
                    <a:xfrm>
                      <a:off x="5479631" y="5731349"/>
                      <a:ext cx="97588" cy="1010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</p:grpSp>
              <p:cxnSp>
                <p:nvCxnSpPr>
                  <p:cNvPr id="138" name="Straight Connector 137"/>
                  <p:cNvCxnSpPr/>
                  <p:nvPr/>
                </p:nvCxnSpPr>
                <p:spPr bwMode="auto">
                  <a:xfrm rot="5400000">
                    <a:off x="2890368" y="5893090"/>
                    <a:ext cx="45720" cy="1272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39" name="TextBox 138"/>
                  <p:cNvSpPr txBox="1"/>
                  <p:nvPr/>
                </p:nvSpPr>
                <p:spPr>
                  <a:xfrm>
                    <a:off x="2910425" y="5853146"/>
                    <a:ext cx="406523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ILC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134" name="TextBox 133"/>
                <p:cNvSpPr txBox="1"/>
                <p:nvPr/>
              </p:nvSpPr>
              <p:spPr>
                <a:xfrm>
                  <a:off x="2298631" y="5059585"/>
                  <a:ext cx="42148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8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5" name="TextBox 134"/>
                <p:cNvSpPr txBox="1"/>
                <p:nvPr/>
              </p:nvSpPr>
              <p:spPr>
                <a:xfrm>
                  <a:off x="2511020" y="4983251"/>
                  <a:ext cx="53689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116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6" name="TextBox 135"/>
                <p:cNvSpPr txBox="1"/>
                <p:nvPr/>
              </p:nvSpPr>
              <p:spPr>
                <a:xfrm>
                  <a:off x="2870280" y="4949929"/>
                  <a:ext cx="42148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4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31" name="TextBox 130"/>
              <p:cNvSpPr txBox="1"/>
              <p:nvPr/>
            </p:nvSpPr>
            <p:spPr>
              <a:xfrm>
                <a:off x="2030227" y="5774866"/>
                <a:ext cx="30393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 rot="16200000">
                <a:off x="1831792" y="5231428"/>
                <a:ext cx="377026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IRS</a:t>
                </a:r>
                <a:endParaRPr lang="en-IN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80" name="Group 240"/>
            <p:cNvGrpSpPr/>
            <p:nvPr/>
          </p:nvGrpSpPr>
          <p:grpSpPr>
            <a:xfrm>
              <a:off x="2773093" y="3167139"/>
              <a:ext cx="1293378" cy="1462561"/>
              <a:chOff x="7253762" y="4657860"/>
              <a:chExt cx="1724505" cy="1462561"/>
            </a:xfrm>
          </p:grpSpPr>
          <p:grpSp>
            <p:nvGrpSpPr>
              <p:cNvPr id="181" name="Group 227"/>
              <p:cNvGrpSpPr/>
              <p:nvPr/>
            </p:nvGrpSpPr>
            <p:grpSpPr>
              <a:xfrm>
                <a:off x="7357606" y="4657860"/>
                <a:ext cx="1620661" cy="1462561"/>
                <a:chOff x="7357606" y="4657860"/>
                <a:chExt cx="1620661" cy="1462561"/>
              </a:xfrm>
            </p:grpSpPr>
            <p:grpSp>
              <p:nvGrpSpPr>
                <p:cNvPr id="184" name="Group 215"/>
                <p:cNvGrpSpPr/>
                <p:nvPr/>
              </p:nvGrpSpPr>
              <p:grpSpPr>
                <a:xfrm>
                  <a:off x="7357606" y="4657860"/>
                  <a:ext cx="1620661" cy="1462561"/>
                  <a:chOff x="4464742" y="4657860"/>
                  <a:chExt cx="1620661" cy="1462561"/>
                </a:xfrm>
              </p:grpSpPr>
              <p:cxnSp>
                <p:nvCxnSpPr>
                  <p:cNvPr id="189" name="Straight Connector 188"/>
                  <p:cNvCxnSpPr/>
                  <p:nvPr/>
                </p:nvCxnSpPr>
                <p:spPr bwMode="auto">
                  <a:xfrm rot="5400000">
                    <a:off x="5947479" y="5883362"/>
                    <a:ext cx="45720" cy="1272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190" name="Group 214"/>
                  <p:cNvGrpSpPr/>
                  <p:nvPr/>
                </p:nvGrpSpPr>
                <p:grpSpPr>
                  <a:xfrm>
                    <a:off x="4464742" y="4657860"/>
                    <a:ext cx="1620661" cy="1462561"/>
                    <a:chOff x="4464742" y="4657860"/>
                    <a:chExt cx="1620661" cy="1462561"/>
                  </a:xfrm>
                </p:grpSpPr>
                <p:grpSp>
                  <p:nvGrpSpPr>
                    <p:cNvPr id="191" name="Group 164"/>
                    <p:cNvGrpSpPr/>
                    <p:nvPr/>
                  </p:nvGrpSpPr>
                  <p:grpSpPr>
                    <a:xfrm>
                      <a:off x="4464742" y="4657860"/>
                      <a:ext cx="1508648" cy="1462561"/>
                      <a:chOff x="1976415" y="4666435"/>
                      <a:chExt cx="1508648" cy="1462561"/>
                    </a:xfrm>
                  </p:grpSpPr>
                  <p:grpSp>
                    <p:nvGrpSpPr>
                      <p:cNvPr id="197" name="Group 159"/>
                      <p:cNvGrpSpPr/>
                      <p:nvPr/>
                    </p:nvGrpSpPr>
                    <p:grpSpPr>
                      <a:xfrm>
                        <a:off x="1976415" y="4666435"/>
                        <a:ext cx="1508648" cy="1460211"/>
                        <a:chOff x="4440723" y="5059627"/>
                        <a:chExt cx="1508648" cy="1460211"/>
                      </a:xfrm>
                    </p:grpSpPr>
                    <p:grpSp>
                      <p:nvGrpSpPr>
                        <p:cNvPr id="200" name="Group 199"/>
                        <p:cNvGrpSpPr/>
                        <p:nvPr/>
                      </p:nvGrpSpPr>
                      <p:grpSpPr>
                        <a:xfrm>
                          <a:off x="4440723" y="5059627"/>
                          <a:ext cx="1508648" cy="1460211"/>
                          <a:chOff x="2007758" y="1141648"/>
                          <a:chExt cx="1882929" cy="2294846"/>
                        </a:xfrm>
                      </p:grpSpPr>
                      <p:grpSp>
                        <p:nvGrpSpPr>
                          <p:cNvPr id="205" name="Group 54"/>
                          <p:cNvGrpSpPr/>
                          <p:nvPr/>
                        </p:nvGrpSpPr>
                        <p:grpSpPr>
                          <a:xfrm>
                            <a:off x="2007758" y="1141648"/>
                            <a:ext cx="1882929" cy="2294846"/>
                            <a:chOff x="1255283" y="1094023"/>
                            <a:chExt cx="1882929" cy="2294846"/>
                          </a:xfrm>
                        </p:grpSpPr>
                        <p:cxnSp>
                          <p:nvCxnSpPr>
                            <p:cNvPr id="208" name="Straight Connector 207"/>
                            <p:cNvCxnSpPr/>
                            <p:nvPr/>
                          </p:nvCxnSpPr>
                          <p:spPr>
                            <a:xfrm rot="5400000">
                              <a:off x="799394" y="2131991"/>
                              <a:ext cx="1828800" cy="1"/>
                            </a:xfrm>
                            <a:prstGeom prst="line">
                              <a:avLst/>
                            </a:prstGeom>
                            <a:ln w="9525"/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  <p:sp>
                          <p:nvSpPr>
                            <p:cNvPr id="209" name="Rectangle 208"/>
                            <p:cNvSpPr/>
                            <p:nvPr/>
                          </p:nvSpPr>
                          <p:spPr>
                            <a:xfrm>
                              <a:off x="1817174" y="1861495"/>
                              <a:ext cx="182882" cy="1135273"/>
                            </a:xfrm>
                            <a:prstGeom prst="rect">
                              <a:avLst/>
                            </a:prstGeom>
                            <a:solidFill>
                              <a:schemeClr val="tx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210" name="Straight Connector 114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 rot="5400000">
                              <a:off x="1643808" y="1894890"/>
                              <a:ext cx="531710" cy="2115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1" name="Straight Connector 115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848884" y="1623709"/>
                              <a:ext cx="121795" cy="1587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2" name="Straight Connector 115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849584" y="2163212"/>
                              <a:ext cx="121795" cy="1587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sp>
                          <p:nvSpPr>
                            <p:cNvPr id="213" name="Rectangle 212"/>
                            <p:cNvSpPr/>
                            <p:nvPr/>
                          </p:nvSpPr>
                          <p:spPr>
                            <a:xfrm>
                              <a:off x="2148211" y="1959771"/>
                              <a:ext cx="182882" cy="1034679"/>
                            </a:xfrm>
                            <a:prstGeom prst="rect">
                              <a:avLst/>
                            </a:prstGeom>
                            <a:solidFill>
                              <a:schemeClr val="tx1"/>
                            </a:solidFill>
                            <a:ln>
                              <a:noFill/>
                            </a:ln>
                          </p:spPr>
                          <p:style>
                            <a:lnRef idx="2">
                              <a:schemeClr val="accent1">
                                <a:shade val="50000"/>
                              </a:schemeClr>
                            </a:lnRef>
                            <a:fillRef idx="1">
                              <a:schemeClr val="accent1"/>
                            </a:fillRef>
                            <a:effectRef idx="0">
                              <a:schemeClr val="accent1"/>
                            </a:effectRef>
                            <a:fontRef idx="minor">
                              <a:schemeClr val="lt1"/>
                            </a:fontRef>
                          </p:style>
                          <p:txBody>
                            <a:bodyPr rtlCol="0" anchor="ctr"/>
                            <a:lstStyle/>
                            <a:p>
                              <a:pPr algn="ctr"/>
                              <a:endParaRPr lang="en-US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214" name="Straight Connector 114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 rot="5400000">
                              <a:off x="2180131" y="1940106"/>
                              <a:ext cx="129335" cy="2115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5" name="Straight Connector 115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2184018" y="1875702"/>
                              <a:ext cx="121795" cy="1587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6" name="Straight Connector 115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2184718" y="2011814"/>
                              <a:ext cx="121795" cy="1587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7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9572" y="1219986"/>
                              <a:ext cx="48006" cy="1587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8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7380" y="1413700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19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6326" y="159366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0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70136" y="176892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1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70136" y="194418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2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70136" y="211563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3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6326" y="229089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4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70136" y="246996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5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6326" y="264522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cxnSp>
                          <p:nvCxnSpPr>
                            <p:cNvPr id="226" name="Straight Connector 29"/>
                            <p:cNvCxnSpPr>
                              <a:cxnSpLocks noChangeShapeType="1"/>
                            </p:cNvCxnSpPr>
                            <p:nvPr/>
                          </p:nvCxnSpPr>
                          <p:spPr bwMode="auto">
                            <a:xfrm>
                              <a:off x="1666326" y="2816678"/>
                              <a:ext cx="48006" cy="1588"/>
                            </a:xfrm>
                            <a:prstGeom prst="line">
                              <a:avLst/>
                            </a:prstGeom>
                            <a:noFill/>
                            <a:ln w="9525" algn="ctr">
                              <a:solidFill>
                                <a:schemeClr val="tx1"/>
                              </a:solidFill>
                              <a:round/>
                              <a:headEnd/>
                              <a:tailEnd/>
                            </a:ln>
                          </p:spPr>
                        </p:cxnSp>
                        <p:sp>
                          <p:nvSpPr>
                            <p:cNvPr id="227" name="TextBox 226"/>
                            <p:cNvSpPr txBox="1"/>
                            <p:nvPr/>
                          </p:nvSpPr>
                          <p:spPr>
                            <a:xfrm>
                              <a:off x="1303140" y="2682885"/>
                              <a:ext cx="616429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1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28" name="TextBox 227"/>
                            <p:cNvSpPr txBox="1"/>
                            <p:nvPr/>
                          </p:nvSpPr>
                          <p:spPr>
                            <a:xfrm>
                              <a:off x="1303137" y="2505025"/>
                              <a:ext cx="616432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2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29" name="TextBox 228"/>
                            <p:cNvSpPr txBox="1"/>
                            <p:nvPr/>
                          </p:nvSpPr>
                          <p:spPr>
                            <a:xfrm>
                              <a:off x="1303729" y="2333034"/>
                              <a:ext cx="615838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3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0" name="TextBox 229"/>
                            <p:cNvSpPr txBox="1"/>
                            <p:nvPr/>
                          </p:nvSpPr>
                          <p:spPr>
                            <a:xfrm>
                              <a:off x="1303730" y="2150982"/>
                              <a:ext cx="615840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4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1" name="TextBox 230"/>
                            <p:cNvSpPr txBox="1"/>
                            <p:nvPr/>
                          </p:nvSpPr>
                          <p:spPr>
                            <a:xfrm>
                              <a:off x="1303722" y="1979603"/>
                              <a:ext cx="615845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5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2" name="TextBox 231"/>
                            <p:cNvSpPr txBox="1"/>
                            <p:nvPr/>
                          </p:nvSpPr>
                          <p:spPr>
                            <a:xfrm>
                              <a:off x="1303134" y="1803001"/>
                              <a:ext cx="616435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6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3" name="TextBox 232"/>
                            <p:cNvSpPr txBox="1"/>
                            <p:nvPr/>
                          </p:nvSpPr>
                          <p:spPr>
                            <a:xfrm>
                              <a:off x="1302537" y="1634957"/>
                              <a:ext cx="617030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7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4" name="TextBox 233"/>
                            <p:cNvSpPr txBox="1"/>
                            <p:nvPr/>
                          </p:nvSpPr>
                          <p:spPr>
                            <a:xfrm>
                              <a:off x="1305500" y="1451239"/>
                              <a:ext cx="614067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8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5" name="TextBox 234"/>
                            <p:cNvSpPr txBox="1"/>
                            <p:nvPr/>
                          </p:nvSpPr>
                          <p:spPr>
                            <a:xfrm>
                              <a:off x="1304316" y="1272744"/>
                              <a:ext cx="496372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9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6" name="TextBox 235"/>
                            <p:cNvSpPr txBox="1"/>
                            <p:nvPr/>
                          </p:nvSpPr>
                          <p:spPr>
                            <a:xfrm>
                              <a:off x="1255283" y="1094023"/>
                              <a:ext cx="664284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squar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100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7" name="TextBox 236"/>
                            <p:cNvSpPr txBox="1"/>
                            <p:nvPr/>
                          </p:nvSpPr>
                          <p:spPr>
                            <a:xfrm rot="19117684">
                              <a:off x="1445287" y="3095877"/>
                              <a:ext cx="712772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Stage I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sp>
                          <p:nvSpPr>
                            <p:cNvPr id="238" name="TextBox 237"/>
                            <p:cNvSpPr txBox="1"/>
                            <p:nvPr/>
                          </p:nvSpPr>
                          <p:spPr>
                            <a:xfrm rot="19313730">
                              <a:off x="1776387" y="3098651"/>
                              <a:ext cx="747450" cy="290218"/>
                            </a:xfrm>
                            <a:prstGeom prst="rect">
                              <a:avLst/>
                            </a:prstGeom>
                            <a:noFill/>
                          </p:spPr>
                          <p:txBody>
                            <a:bodyPr wrap="none" rtlCol="0">
                              <a:spAutoFit/>
                            </a:bodyPr>
                            <a:lstStyle/>
                            <a:p>
                              <a:r>
                                <a:rPr lang="en-US" sz="600" dirty="0" smtClean="0">
                                  <a:latin typeface="Arial" pitchFamily="34" charset="0"/>
                                  <a:cs typeface="Arial" pitchFamily="34" charset="0"/>
                                </a:rPr>
                                <a:t>Stage II</a:t>
                              </a:r>
                              <a:endParaRPr lang="en-US" sz="600" dirty="0">
                                <a:latin typeface="Arial" pitchFamily="34" charset="0"/>
                                <a:cs typeface="Arial" pitchFamily="34" charset="0"/>
                              </a:endParaRPr>
                            </a:p>
                          </p:txBody>
                        </p:sp>
                        <p:cxnSp>
                          <p:nvCxnSpPr>
                            <p:cNvPr id="239" name="Straight Connector 238"/>
                            <p:cNvCxnSpPr/>
                            <p:nvPr/>
                          </p:nvCxnSpPr>
                          <p:spPr>
                            <a:xfrm rot="10800000">
                              <a:off x="1666015" y="2991694"/>
                              <a:ext cx="1472197" cy="2"/>
                            </a:xfrm>
                            <a:prstGeom prst="line">
                              <a:avLst/>
                            </a:prstGeom>
                            <a:ln w="9525"/>
                          </p:spPr>
                          <p:style>
                            <a:lnRef idx="1">
                              <a:schemeClr val="dk1"/>
                            </a:lnRef>
                            <a:fillRef idx="0">
                              <a:schemeClr val="dk1"/>
                            </a:fillRef>
                            <a:effectRef idx="0">
                              <a:schemeClr val="dk1"/>
                            </a:effectRef>
                            <a:fontRef idx="minor">
                              <a:schemeClr val="tx1"/>
                            </a:fontRef>
                          </p:style>
                        </p:cxnSp>
                      </p:grpSp>
                      <p:cxnSp>
                        <p:nvCxnSpPr>
                          <p:cNvPr id="206" name="Straight Connector 205"/>
                          <p:cNvCxnSpPr/>
                          <p:nvPr/>
                        </p:nvCxnSpPr>
                        <p:spPr bwMode="auto">
                          <a:xfrm rot="5400000">
                            <a:off x="2796672" y="3067243"/>
                            <a:ext cx="71853" cy="1588"/>
                          </a:xfrm>
                          <a:prstGeom prst="line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cxnSp>
                        <p:nvCxnSpPr>
                          <p:cNvPr id="207" name="Straight Connector 206"/>
                          <p:cNvCxnSpPr/>
                          <p:nvPr/>
                        </p:nvCxnSpPr>
                        <p:spPr bwMode="auto">
                          <a:xfrm rot="5400000">
                            <a:off x="3504608" y="3069937"/>
                            <a:ext cx="71853" cy="1588"/>
                          </a:xfrm>
                          <a:prstGeom prst="line">
                            <a:avLst/>
                          </a:prstGeom>
                          <a:ln w="9525">
                            <a:solidFill>
                              <a:schemeClr val="tx1"/>
                            </a:solidFill>
                          </a:ln>
                        </p:spPr>
                        <p:style>
                          <a:lnRef idx="1">
                            <a:schemeClr val="accent1"/>
                          </a:lnRef>
                          <a:fillRef idx="0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sp>
                      <p:nvSpPr>
                        <p:cNvPr id="201" name="Rectangle 200"/>
                        <p:cNvSpPr/>
                        <p:nvPr/>
                      </p:nvSpPr>
                      <p:spPr>
                        <a:xfrm>
                          <a:off x="5450335" y="5561285"/>
                          <a:ext cx="146532" cy="704088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202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5413470" y="5538807"/>
                          <a:ext cx="228600" cy="169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203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5479070" y="5428093"/>
                          <a:ext cx="97588" cy="1010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204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5479631" y="5661005"/>
                          <a:ext cx="97588" cy="1010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</p:grpSp>
                  <p:cxnSp>
                    <p:nvCxnSpPr>
                      <p:cNvPr id="198" name="Straight Connector 197"/>
                      <p:cNvCxnSpPr/>
                      <p:nvPr/>
                    </p:nvCxnSpPr>
                    <p:spPr bwMode="auto">
                      <a:xfrm rot="5400000">
                        <a:off x="2890368" y="5893090"/>
                        <a:ext cx="45720" cy="1272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99" name="TextBox 198"/>
                      <p:cNvSpPr txBox="1"/>
                      <p:nvPr/>
                    </p:nvSpPr>
                    <p:spPr>
                      <a:xfrm rot="19239801">
                        <a:off x="2665758" y="5944330"/>
                        <a:ext cx="626668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Stage III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sp>
                  <p:nvSpPr>
                    <p:cNvPr id="192" name="Rectangle 191"/>
                    <p:cNvSpPr/>
                    <p:nvPr/>
                  </p:nvSpPr>
                  <p:spPr>
                    <a:xfrm>
                      <a:off x="5750769" y="5209753"/>
                      <a:ext cx="146532" cy="658368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cxnSp>
                  <p:nvCxnSpPr>
                    <p:cNvPr id="193" name="Straight Connector 114"/>
                    <p:cNvCxnSpPr>
                      <a:cxnSpLocks noChangeShapeType="1"/>
                    </p:cNvCxnSpPr>
                    <p:nvPr/>
                  </p:nvCxnSpPr>
                  <p:spPr bwMode="auto">
                    <a:xfrm rot="5400000">
                      <a:off x="5644753" y="5143136"/>
                      <a:ext cx="365760" cy="1695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  <p:cxnSp>
                  <p:nvCxnSpPr>
                    <p:cNvPr id="194" name="Straight Connector 115"/>
                    <p:cNvCxnSpPr>
                      <a:cxnSpLocks noChangeShapeType="1"/>
                    </p:cNvCxnSpPr>
                    <p:nvPr/>
                  </p:nvCxnSpPr>
                  <p:spPr bwMode="auto">
                    <a:xfrm>
                      <a:off x="5778933" y="4954698"/>
                      <a:ext cx="97588" cy="1010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  <p:cxnSp>
                  <p:nvCxnSpPr>
                    <p:cNvPr id="195" name="Straight Connector 115"/>
                    <p:cNvCxnSpPr>
                      <a:cxnSpLocks noChangeShapeType="1"/>
                    </p:cNvCxnSpPr>
                    <p:nvPr/>
                  </p:nvCxnSpPr>
                  <p:spPr bwMode="auto">
                    <a:xfrm>
                      <a:off x="5779494" y="5320198"/>
                      <a:ext cx="97588" cy="1010"/>
                    </a:xfrm>
                    <a:prstGeom prst="line">
                      <a:avLst/>
                    </a:prstGeom>
                    <a:noFill/>
                    <a:ln w="9525" algn="ctr">
                      <a:solidFill>
                        <a:schemeClr val="tx1"/>
                      </a:solidFill>
                      <a:round/>
                      <a:headEnd/>
                      <a:tailEnd/>
                    </a:ln>
                  </p:spPr>
                </p:cxnSp>
                <p:sp>
                  <p:nvSpPr>
                    <p:cNvPr id="196" name="TextBox 195"/>
                    <p:cNvSpPr txBox="1"/>
                    <p:nvPr/>
                  </p:nvSpPr>
                  <p:spPr>
                    <a:xfrm rot="19102330">
                      <a:off x="5445911" y="5934166"/>
                      <a:ext cx="63949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Stage IV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</p:grpSp>
            <p:sp>
              <p:nvSpPr>
                <p:cNvPr id="185" name="TextBox 184"/>
                <p:cNvSpPr txBox="1"/>
                <p:nvPr/>
              </p:nvSpPr>
              <p:spPr>
                <a:xfrm>
                  <a:off x="7690606" y="4849131"/>
                  <a:ext cx="42148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3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6" name="TextBox 185"/>
                <p:cNvSpPr txBox="1"/>
                <p:nvPr/>
              </p:nvSpPr>
              <p:spPr>
                <a:xfrm>
                  <a:off x="7933526" y="5007073"/>
                  <a:ext cx="4791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68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8230019" y="4874753"/>
                  <a:ext cx="47919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39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8510807" y="4801317"/>
                  <a:ext cx="42148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n=6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182" name="TextBox 181"/>
              <p:cNvSpPr txBox="1"/>
              <p:nvPr/>
            </p:nvSpPr>
            <p:spPr>
              <a:xfrm>
                <a:off x="7434705" y="5768866"/>
                <a:ext cx="303931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0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" name="TextBox 182"/>
              <p:cNvSpPr txBox="1"/>
              <p:nvPr/>
            </p:nvSpPr>
            <p:spPr>
              <a:xfrm rot="16200000">
                <a:off x="7219137" y="5218093"/>
                <a:ext cx="377026" cy="3077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>
                    <a:latin typeface="Arial" pitchFamily="34" charset="0"/>
                    <a:cs typeface="Arial" pitchFamily="34" charset="0"/>
                  </a:rPr>
                  <a:t>IRS</a:t>
                </a:r>
                <a:endParaRPr lang="en-IN" sz="9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32" name="Group 397"/>
            <p:cNvGrpSpPr/>
            <p:nvPr/>
          </p:nvGrpSpPr>
          <p:grpSpPr>
            <a:xfrm>
              <a:off x="508447" y="3176962"/>
              <a:ext cx="1105223" cy="1393580"/>
              <a:chOff x="290019" y="4523415"/>
              <a:chExt cx="1105223" cy="1393580"/>
            </a:xfrm>
          </p:grpSpPr>
          <p:grpSp>
            <p:nvGrpSpPr>
              <p:cNvPr id="333" name="Group 248"/>
              <p:cNvGrpSpPr/>
              <p:nvPr/>
            </p:nvGrpSpPr>
            <p:grpSpPr>
              <a:xfrm>
                <a:off x="290019" y="4523415"/>
                <a:ext cx="1079788" cy="1393580"/>
                <a:chOff x="729773" y="1977187"/>
                <a:chExt cx="1439716" cy="1393580"/>
              </a:xfrm>
            </p:grpSpPr>
            <p:grpSp>
              <p:nvGrpSpPr>
                <p:cNvPr id="335" name="Group 229"/>
                <p:cNvGrpSpPr/>
                <p:nvPr/>
              </p:nvGrpSpPr>
              <p:grpSpPr>
                <a:xfrm>
                  <a:off x="834998" y="1981544"/>
                  <a:ext cx="1334491" cy="1389223"/>
                  <a:chOff x="2044673" y="1162394"/>
                  <a:chExt cx="1334491" cy="1389223"/>
                </a:xfrm>
              </p:grpSpPr>
              <p:grpSp>
                <p:nvGrpSpPr>
                  <p:cNvPr id="340" name="Group 104"/>
                  <p:cNvGrpSpPr/>
                  <p:nvPr/>
                </p:nvGrpSpPr>
                <p:grpSpPr>
                  <a:xfrm>
                    <a:off x="2044673" y="1162394"/>
                    <a:ext cx="1264471" cy="1389223"/>
                    <a:chOff x="2023441" y="1147112"/>
                    <a:chExt cx="1578127" cy="2183272"/>
                  </a:xfrm>
                </p:grpSpPr>
                <p:grpSp>
                  <p:nvGrpSpPr>
                    <p:cNvPr id="343" name="Group 54"/>
                    <p:cNvGrpSpPr/>
                    <p:nvPr/>
                  </p:nvGrpSpPr>
                  <p:grpSpPr>
                    <a:xfrm>
                      <a:off x="2023441" y="1147112"/>
                      <a:ext cx="1578127" cy="2183272"/>
                      <a:chOff x="1270966" y="1099487"/>
                      <a:chExt cx="1578127" cy="2183272"/>
                    </a:xfrm>
                  </p:grpSpPr>
                  <p:cxnSp>
                    <p:nvCxnSpPr>
                      <p:cNvPr id="346" name="Straight Connector 345"/>
                      <p:cNvCxnSpPr/>
                      <p:nvPr/>
                    </p:nvCxnSpPr>
                    <p:spPr>
                      <a:xfrm rot="5400000">
                        <a:off x="799394" y="2131991"/>
                        <a:ext cx="1828800" cy="1"/>
                      </a:xfrm>
                      <a:prstGeom prst="line">
                        <a:avLst/>
                      </a:prstGeom>
                      <a:ln w="952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47" name="Straight Connector 346"/>
                      <p:cNvCxnSpPr/>
                      <p:nvPr/>
                    </p:nvCxnSpPr>
                    <p:spPr>
                      <a:xfrm rot="10800000">
                        <a:off x="1660373" y="2991693"/>
                        <a:ext cx="1188720" cy="1"/>
                      </a:xfrm>
                      <a:prstGeom prst="line">
                        <a:avLst/>
                      </a:prstGeom>
                      <a:ln w="9525"/>
                    </p:spPr>
                    <p:style>
                      <a:lnRef idx="1">
                        <a:schemeClr val="dk1"/>
                      </a:lnRef>
                      <a:fillRef idx="0">
                        <a:schemeClr val="dk1"/>
                      </a:fillRef>
                      <a:effectRef idx="0">
                        <a:schemeClr val="dk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348" name="Rectangle 347"/>
                      <p:cNvSpPr/>
                      <p:nvPr/>
                    </p:nvSpPr>
                    <p:spPr>
                      <a:xfrm>
                        <a:off x="1919830" y="1719896"/>
                        <a:ext cx="182880" cy="1271016"/>
                      </a:xfrm>
                      <a:prstGeom prst="rect">
                        <a:avLst/>
                      </a:pr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cxnSp>
                    <p:nvCxnSpPr>
                      <p:cNvPr id="349" name="Straight Connector 114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 rot="5400000">
                        <a:off x="1974290" y="1718264"/>
                        <a:ext cx="76162" cy="2115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0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951591" y="1680448"/>
                        <a:ext cx="121795" cy="1587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1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952291" y="1750847"/>
                        <a:ext cx="121795" cy="1587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sp>
                    <p:nvSpPr>
                      <p:cNvPr id="352" name="Rectangle 351"/>
                      <p:cNvSpPr/>
                      <p:nvPr/>
                    </p:nvSpPr>
                    <p:spPr>
                      <a:xfrm>
                        <a:off x="2513346" y="2507254"/>
                        <a:ext cx="182880" cy="484632"/>
                      </a:xfrm>
                      <a:prstGeom prst="rect">
                        <a:avLst/>
                      </a:pr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cxnSp>
                    <p:nvCxnSpPr>
                      <p:cNvPr id="353" name="Straight Connector 114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 rot="5400000">
                        <a:off x="2559689" y="2510491"/>
                        <a:ext cx="100594" cy="2115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4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2549207" y="2452340"/>
                        <a:ext cx="121795" cy="1587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5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2549906" y="2563333"/>
                        <a:ext cx="121795" cy="1587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6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9574" y="1241844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7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7380" y="1413700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8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6326" y="159366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59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70136" y="176892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0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70136" y="194418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1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70136" y="211563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2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6326" y="229089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3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70136" y="246996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4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6326" y="264522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365" name="Straight Connector 29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1666326" y="2816678"/>
                        <a:ext cx="48006" cy="1588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sp>
                    <p:nvSpPr>
                      <p:cNvPr id="366" name="TextBox 365"/>
                      <p:cNvSpPr txBox="1"/>
                      <p:nvPr/>
                    </p:nvSpPr>
                    <p:spPr>
                      <a:xfrm>
                        <a:off x="1334843" y="2682885"/>
                        <a:ext cx="546364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1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67" name="TextBox 366"/>
                      <p:cNvSpPr txBox="1"/>
                      <p:nvPr/>
                    </p:nvSpPr>
                    <p:spPr>
                      <a:xfrm>
                        <a:off x="1334840" y="2505025"/>
                        <a:ext cx="54636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2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68" name="TextBox 367"/>
                      <p:cNvSpPr txBox="1"/>
                      <p:nvPr/>
                    </p:nvSpPr>
                    <p:spPr>
                      <a:xfrm>
                        <a:off x="1323750" y="2333034"/>
                        <a:ext cx="56025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3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69" name="TextBox 368"/>
                      <p:cNvSpPr txBox="1"/>
                      <p:nvPr/>
                    </p:nvSpPr>
                    <p:spPr>
                      <a:xfrm>
                        <a:off x="1335432" y="2150982"/>
                        <a:ext cx="545775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4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0" name="TextBox 369"/>
                      <p:cNvSpPr txBox="1"/>
                      <p:nvPr/>
                    </p:nvSpPr>
                    <p:spPr>
                      <a:xfrm>
                        <a:off x="1323743" y="1979602"/>
                        <a:ext cx="56025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5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1" name="TextBox 370"/>
                      <p:cNvSpPr txBox="1"/>
                      <p:nvPr/>
                    </p:nvSpPr>
                    <p:spPr>
                      <a:xfrm>
                        <a:off x="1323153" y="1803002"/>
                        <a:ext cx="56025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6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2" name="TextBox 371"/>
                      <p:cNvSpPr txBox="1"/>
                      <p:nvPr/>
                    </p:nvSpPr>
                    <p:spPr>
                      <a:xfrm>
                        <a:off x="1344807" y="1634957"/>
                        <a:ext cx="546965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7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3" name="TextBox 372"/>
                      <p:cNvSpPr txBox="1"/>
                      <p:nvPr/>
                    </p:nvSpPr>
                    <p:spPr>
                      <a:xfrm>
                        <a:off x="1325521" y="1451240"/>
                        <a:ext cx="56025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8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4" name="TextBox 373"/>
                      <p:cNvSpPr txBox="1"/>
                      <p:nvPr/>
                    </p:nvSpPr>
                    <p:spPr>
                      <a:xfrm>
                        <a:off x="1336018" y="1272744"/>
                        <a:ext cx="66406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9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5" name="TextBox 374"/>
                      <p:cNvSpPr txBox="1"/>
                      <p:nvPr/>
                    </p:nvSpPr>
                    <p:spPr>
                      <a:xfrm>
                        <a:off x="1270966" y="1099487"/>
                        <a:ext cx="717437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100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376" name="TextBox 97"/>
                      <p:cNvSpPr txBox="1"/>
                      <p:nvPr/>
                    </p:nvSpPr>
                    <p:spPr>
                      <a:xfrm>
                        <a:off x="1677468" y="2992542"/>
                        <a:ext cx="734098" cy="290217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600" dirty="0" smtClean="0">
                            <a:latin typeface="Arial" pitchFamily="34" charset="0"/>
                            <a:cs typeface="Arial" pitchFamily="34" charset="0"/>
                          </a:rPr>
                          <a:t>Group I</a:t>
                        </a:r>
                        <a:endParaRPr lang="en-US" sz="600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</p:grpSp>
                <p:cxnSp>
                  <p:nvCxnSpPr>
                    <p:cNvPr id="344" name="Straight Connector 343"/>
                    <p:cNvCxnSpPr/>
                    <p:nvPr/>
                  </p:nvCxnSpPr>
                  <p:spPr bwMode="auto">
                    <a:xfrm rot="5400000">
                      <a:off x="3020477" y="3054563"/>
                      <a:ext cx="46493" cy="158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5" name="Straight Connector 344"/>
                    <p:cNvCxnSpPr/>
                    <p:nvPr/>
                  </p:nvCxnSpPr>
                  <p:spPr bwMode="auto">
                    <a:xfrm rot="5400000">
                      <a:off x="3574189" y="3057256"/>
                      <a:ext cx="46493" cy="1588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41" name="TextBox 340"/>
                  <p:cNvSpPr txBox="1"/>
                  <p:nvPr/>
                </p:nvSpPr>
                <p:spPr>
                  <a:xfrm>
                    <a:off x="2436308" y="1376634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88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342" name="TextBox 341"/>
                  <p:cNvSpPr txBox="1"/>
                  <p:nvPr/>
                </p:nvSpPr>
                <p:spPr>
                  <a:xfrm>
                    <a:off x="2899972" y="1860618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28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336" name="TextBox 335"/>
                <p:cNvSpPr txBox="1"/>
                <p:nvPr/>
              </p:nvSpPr>
              <p:spPr>
                <a:xfrm>
                  <a:off x="912474" y="3091056"/>
                  <a:ext cx="497361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7" name="Left Brace 336"/>
                <p:cNvSpPr/>
                <p:nvPr/>
              </p:nvSpPr>
              <p:spPr>
                <a:xfrm rot="16200000" flipH="1" flipV="1">
                  <a:off x="1641821" y="1871201"/>
                  <a:ext cx="91440" cy="640080"/>
                </a:xfrm>
                <a:prstGeom prst="leftBrac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8" name="TextBox 337"/>
                <p:cNvSpPr txBox="1"/>
                <p:nvPr/>
              </p:nvSpPr>
              <p:spPr>
                <a:xfrm>
                  <a:off x="1483314" y="1977187"/>
                  <a:ext cx="4043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 smtClean="0">
                      <a:latin typeface="Arial" pitchFamily="34" charset="0"/>
                      <a:cs typeface="Arial" pitchFamily="34" charset="0"/>
                    </a:rPr>
                    <a:t>**</a:t>
                  </a:r>
                  <a:endParaRPr lang="en-US" sz="12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339" name="TextBox 338"/>
                <p:cNvSpPr txBox="1"/>
                <p:nvPr/>
              </p:nvSpPr>
              <p:spPr>
                <a:xfrm rot="16200000">
                  <a:off x="679118" y="2509183"/>
                  <a:ext cx="409086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Arial" pitchFamily="34" charset="0"/>
                      <a:cs typeface="Arial" pitchFamily="34" charset="0"/>
                    </a:rPr>
                    <a:t>IRS </a:t>
                  </a:r>
                  <a:endParaRPr lang="en-IN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34" name="TextBox 333"/>
              <p:cNvSpPr txBox="1"/>
              <p:nvPr/>
            </p:nvSpPr>
            <p:spPr>
              <a:xfrm>
                <a:off x="933256" y="5730875"/>
                <a:ext cx="46198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Group II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85" name="Group 384"/>
            <p:cNvGrpSpPr/>
            <p:nvPr/>
          </p:nvGrpSpPr>
          <p:grpSpPr>
            <a:xfrm>
              <a:off x="519101" y="4776002"/>
              <a:ext cx="1072221" cy="1649835"/>
              <a:chOff x="519101" y="4776002"/>
              <a:chExt cx="1072221" cy="1649835"/>
            </a:xfrm>
          </p:grpSpPr>
          <p:grpSp>
            <p:nvGrpSpPr>
              <p:cNvPr id="240" name="Group 254"/>
              <p:cNvGrpSpPr/>
              <p:nvPr/>
            </p:nvGrpSpPr>
            <p:grpSpPr>
              <a:xfrm>
                <a:off x="519101" y="4852214"/>
                <a:ext cx="1072221" cy="1573623"/>
                <a:chOff x="1407317" y="1415791"/>
                <a:chExt cx="1429627" cy="1573623"/>
              </a:xfrm>
            </p:grpSpPr>
            <p:grpSp>
              <p:nvGrpSpPr>
                <p:cNvPr id="241" name="Group 13"/>
                <p:cNvGrpSpPr/>
                <p:nvPr/>
              </p:nvGrpSpPr>
              <p:grpSpPr>
                <a:xfrm>
                  <a:off x="1507327" y="1415791"/>
                  <a:ext cx="1329617" cy="1573623"/>
                  <a:chOff x="2005040" y="4660386"/>
                  <a:chExt cx="1329617" cy="1573623"/>
                </a:xfrm>
              </p:grpSpPr>
              <p:grpSp>
                <p:nvGrpSpPr>
                  <p:cNvPr id="244" name="Group 163"/>
                  <p:cNvGrpSpPr/>
                  <p:nvPr/>
                </p:nvGrpSpPr>
                <p:grpSpPr>
                  <a:xfrm>
                    <a:off x="2005040" y="4660386"/>
                    <a:ext cx="1230181" cy="1573623"/>
                    <a:chOff x="2005040" y="4660386"/>
                    <a:chExt cx="1230181" cy="1573623"/>
                  </a:xfrm>
                </p:grpSpPr>
                <p:grpSp>
                  <p:nvGrpSpPr>
                    <p:cNvPr id="248" name="Group 159"/>
                    <p:cNvGrpSpPr/>
                    <p:nvPr/>
                  </p:nvGrpSpPr>
                  <p:grpSpPr>
                    <a:xfrm>
                      <a:off x="2005040" y="4660386"/>
                      <a:ext cx="1230181" cy="1437139"/>
                      <a:chOff x="4469348" y="5053578"/>
                      <a:chExt cx="1230181" cy="1437139"/>
                    </a:xfrm>
                  </p:grpSpPr>
                  <p:grpSp>
                    <p:nvGrpSpPr>
                      <p:cNvPr id="251" name="Group 116"/>
                      <p:cNvGrpSpPr/>
                      <p:nvPr/>
                    </p:nvGrpSpPr>
                    <p:grpSpPr>
                      <a:xfrm>
                        <a:off x="4469348" y="5053578"/>
                        <a:ext cx="1230181" cy="1437139"/>
                        <a:chOff x="2043410" y="1132143"/>
                        <a:chExt cx="1535338" cy="2258583"/>
                      </a:xfrm>
                    </p:grpSpPr>
                    <p:grpSp>
                      <p:nvGrpSpPr>
                        <p:cNvPr id="256" name="Group 54"/>
                        <p:cNvGrpSpPr/>
                        <p:nvPr/>
                      </p:nvGrpSpPr>
                      <p:grpSpPr>
                        <a:xfrm>
                          <a:off x="2043410" y="1132143"/>
                          <a:ext cx="1535338" cy="2258583"/>
                          <a:chOff x="1290935" y="1084518"/>
                          <a:chExt cx="1535338" cy="2258583"/>
                        </a:xfrm>
                      </p:grpSpPr>
                      <p:cxnSp>
                        <p:nvCxnSpPr>
                          <p:cNvPr id="259" name="Straight Connector 258"/>
                          <p:cNvCxnSpPr/>
                          <p:nvPr/>
                        </p:nvCxnSpPr>
                        <p:spPr>
                          <a:xfrm rot="5400000">
                            <a:off x="799394" y="2131991"/>
                            <a:ext cx="1828800" cy="1"/>
                          </a:xfrm>
                          <a:prstGeom prst="line">
                            <a:avLst/>
                          </a:prstGeom>
                          <a:ln w="9525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  <p:sp>
                        <p:nvSpPr>
                          <p:cNvPr id="260" name="Rectangle 259"/>
                          <p:cNvSpPr/>
                          <p:nvPr/>
                        </p:nvSpPr>
                        <p:spPr>
                          <a:xfrm>
                            <a:off x="1817121" y="1880220"/>
                            <a:ext cx="182881" cy="1120902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261" name="Straight Connector 114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 rot="5400000">
                            <a:off x="1809070" y="1882993"/>
                            <a:ext cx="201186" cy="2115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2" name="Straight Connector 115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848884" y="1777072"/>
                            <a:ext cx="121795" cy="1587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3" name="Straight Connector 115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849584" y="1985447"/>
                            <a:ext cx="121795" cy="1587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sp>
                        <p:nvSpPr>
                          <p:cNvPr id="264" name="Rectangle 263"/>
                          <p:cNvSpPr/>
                          <p:nvPr/>
                        </p:nvSpPr>
                        <p:spPr>
                          <a:xfrm>
                            <a:off x="2148155" y="1879034"/>
                            <a:ext cx="182881" cy="1120902"/>
                          </a:xfrm>
                          <a:prstGeom prst="rect">
                            <a:avLst/>
                          </a:prstGeom>
                          <a:solidFill>
                            <a:schemeClr val="tx1"/>
                          </a:solidFill>
                          <a:ln>
                            <a:noFill/>
                          </a:ln>
                        </p:spPr>
                        <p:style>
                          <a:lnRef idx="2">
                            <a:schemeClr val="accent1">
                              <a:shade val="50000"/>
                            </a:schemeClr>
                          </a:lnRef>
                          <a:fillRef idx="1">
                            <a:schemeClr val="accent1"/>
                          </a:fillRef>
                          <a:effectRef idx="0">
                            <a:schemeClr val="accent1"/>
                          </a:effectRef>
                          <a:fontRef idx="minor">
                            <a:schemeClr val="lt1"/>
                          </a:fontRef>
                        </p:style>
                        <p:txBody>
                          <a:bodyPr rtlCol="0" anchor="ctr"/>
                          <a:lstStyle/>
                          <a:p>
                            <a:pPr algn="ctr"/>
                            <a:endParaRPr lang="en-US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265" name="Straight Connector 114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 rot="5400000">
                            <a:off x="2108278" y="1830829"/>
                            <a:ext cx="273041" cy="2115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6" name="Straight Connector 115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2184018" y="1686453"/>
                            <a:ext cx="121795" cy="1587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7" name="Straight Connector 115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2184718" y="1962560"/>
                            <a:ext cx="121795" cy="1587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8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9574" y="1227826"/>
                            <a:ext cx="48007" cy="1587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69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7380" y="1413700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0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6326" y="159366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1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70136" y="176892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2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70136" y="194418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3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70136" y="211563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4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6326" y="229089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5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70136" y="246996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6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6326" y="264522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cxnSp>
                        <p:nvCxnSpPr>
                          <p:cNvPr id="277" name="Straight Connector 29"/>
                          <p:cNvCxnSpPr>
                            <a:cxnSpLocks noChangeShapeType="1"/>
                          </p:cNvCxnSpPr>
                          <p:nvPr/>
                        </p:nvCxnSpPr>
                        <p:spPr bwMode="auto">
                          <a:xfrm>
                            <a:off x="1666326" y="2816678"/>
                            <a:ext cx="48006" cy="1588"/>
                          </a:xfrm>
                          <a:prstGeom prst="line">
                            <a:avLst/>
                          </a:prstGeom>
                          <a:noFill/>
                          <a:ln w="9525" algn="ctr">
                            <a:solidFill>
                              <a:schemeClr val="tx1"/>
                            </a:solidFill>
                            <a:round/>
                            <a:headEnd/>
                            <a:tailEnd/>
                          </a:ln>
                        </p:spPr>
                      </p:cxnSp>
                      <p:sp>
                        <p:nvSpPr>
                          <p:cNvPr id="278" name="TextBox 277"/>
                          <p:cNvSpPr txBox="1"/>
                          <p:nvPr/>
                        </p:nvSpPr>
                        <p:spPr>
                          <a:xfrm>
                            <a:off x="1328502" y="2682884"/>
                            <a:ext cx="480776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1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79" name="TextBox 278"/>
                          <p:cNvSpPr txBox="1"/>
                          <p:nvPr/>
                        </p:nvSpPr>
                        <p:spPr>
                          <a:xfrm>
                            <a:off x="1341180" y="2505023"/>
                            <a:ext cx="480779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2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0" name="TextBox 279"/>
                          <p:cNvSpPr txBox="1"/>
                          <p:nvPr/>
                        </p:nvSpPr>
                        <p:spPr>
                          <a:xfrm>
                            <a:off x="1354455" y="2333032"/>
                            <a:ext cx="478070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3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1" name="TextBox 280"/>
                          <p:cNvSpPr txBox="1"/>
                          <p:nvPr/>
                        </p:nvSpPr>
                        <p:spPr>
                          <a:xfrm>
                            <a:off x="1354453" y="2150982"/>
                            <a:ext cx="480187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4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2" name="TextBox 281"/>
                          <p:cNvSpPr txBox="1"/>
                          <p:nvPr/>
                        </p:nvSpPr>
                        <p:spPr>
                          <a:xfrm>
                            <a:off x="1329089" y="1979600"/>
                            <a:ext cx="540147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5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3" name="TextBox 282"/>
                          <p:cNvSpPr txBox="1"/>
                          <p:nvPr/>
                        </p:nvSpPr>
                        <p:spPr>
                          <a:xfrm>
                            <a:off x="1353857" y="1802999"/>
                            <a:ext cx="480783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6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4" name="TextBox 283"/>
                          <p:cNvSpPr txBox="1"/>
                          <p:nvPr/>
                        </p:nvSpPr>
                        <p:spPr>
                          <a:xfrm>
                            <a:off x="1327903" y="1634959"/>
                            <a:ext cx="481377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7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5" name="TextBox 284"/>
                          <p:cNvSpPr txBox="1"/>
                          <p:nvPr/>
                        </p:nvSpPr>
                        <p:spPr>
                          <a:xfrm>
                            <a:off x="1330865" y="1451239"/>
                            <a:ext cx="448984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8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6" name="TextBox 285"/>
                          <p:cNvSpPr txBox="1"/>
                          <p:nvPr/>
                        </p:nvSpPr>
                        <p:spPr>
                          <a:xfrm>
                            <a:off x="1329680" y="1272743"/>
                            <a:ext cx="539556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9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7" name="TextBox 286"/>
                          <p:cNvSpPr txBox="1"/>
                          <p:nvPr/>
                        </p:nvSpPr>
                        <p:spPr>
                          <a:xfrm>
                            <a:off x="1290935" y="1084518"/>
                            <a:ext cx="578299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squar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100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8" name="TextBox 287"/>
                          <p:cNvSpPr txBox="1"/>
                          <p:nvPr/>
                        </p:nvSpPr>
                        <p:spPr>
                          <a:xfrm rot="18917494">
                            <a:off x="1432805" y="3051860"/>
                            <a:ext cx="736771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Grade1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sp>
                        <p:nvSpPr>
                          <p:cNvPr id="289" name="TextBox 288"/>
                          <p:cNvSpPr txBox="1"/>
                          <p:nvPr/>
                        </p:nvSpPr>
                        <p:spPr>
                          <a:xfrm rot="18922278">
                            <a:off x="1787174" y="3052883"/>
                            <a:ext cx="736771" cy="290218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600" dirty="0" smtClean="0">
                                <a:latin typeface="Arial" pitchFamily="34" charset="0"/>
                                <a:cs typeface="Arial" pitchFamily="34" charset="0"/>
                              </a:rPr>
                              <a:t>Grade2</a:t>
                            </a:r>
                            <a:endParaRPr lang="en-US" sz="600" dirty="0">
                              <a:latin typeface="Arial" pitchFamily="34" charset="0"/>
                              <a:cs typeface="Arial" pitchFamily="34" charset="0"/>
                            </a:endParaRPr>
                          </a:p>
                        </p:txBody>
                      </p:sp>
                      <p:cxnSp>
                        <p:nvCxnSpPr>
                          <p:cNvPr id="290" name="Straight Connector 289"/>
                          <p:cNvCxnSpPr/>
                          <p:nvPr/>
                        </p:nvCxnSpPr>
                        <p:spPr>
                          <a:xfrm rot="10800000">
                            <a:off x="1662228" y="2991694"/>
                            <a:ext cx="1164045" cy="2"/>
                          </a:xfrm>
                          <a:prstGeom prst="line">
                            <a:avLst/>
                          </a:prstGeom>
                          <a:ln w="9525"/>
                        </p:spPr>
                        <p:style>
                          <a:lnRef idx="1">
                            <a:schemeClr val="dk1"/>
                          </a:lnRef>
                          <a:fillRef idx="0">
                            <a:schemeClr val="dk1"/>
                          </a:fillRef>
                          <a:effectRef idx="0">
                            <a:schemeClr val="dk1"/>
                          </a:effectRef>
                          <a:fontRef idx="minor">
                            <a:schemeClr val="tx1"/>
                          </a:fontRef>
                        </p:style>
                      </p:cxnSp>
                    </p:grpSp>
                    <p:cxnSp>
                      <p:nvCxnSpPr>
                        <p:cNvPr id="257" name="Straight Connector 256"/>
                        <p:cNvCxnSpPr/>
                        <p:nvPr/>
                      </p:nvCxnSpPr>
                      <p:spPr bwMode="auto">
                        <a:xfrm rot="5400000">
                          <a:off x="2796672" y="3067243"/>
                          <a:ext cx="71853" cy="1588"/>
                        </a:xfrm>
                        <a:prstGeom prst="line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  <p:cxnSp>
                      <p:nvCxnSpPr>
                        <p:cNvPr id="258" name="Straight Connector 257"/>
                        <p:cNvCxnSpPr/>
                        <p:nvPr/>
                      </p:nvCxnSpPr>
                      <p:spPr bwMode="auto">
                        <a:xfrm rot="5400000">
                          <a:off x="3538687" y="3069936"/>
                          <a:ext cx="71853" cy="1588"/>
                        </a:xfrm>
                        <a:prstGeom prst="line">
                          <a:avLst/>
                        </a:prstGeom>
                        <a:ln w="9525">
                          <a:solidFill>
                            <a:schemeClr val="tx1"/>
                          </a:solidFill>
                        </a:ln>
                      </p:spPr>
                      <p:style>
                        <a:lnRef idx="1">
                          <a:schemeClr val="accent1"/>
                        </a:lnRef>
                        <a:fillRef idx="0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sp>
                    <p:nvSpPr>
                      <p:cNvPr id="252" name="Rectangle 251"/>
                      <p:cNvSpPr/>
                      <p:nvPr/>
                    </p:nvSpPr>
                    <p:spPr>
                      <a:xfrm>
                        <a:off x="5450335" y="5612935"/>
                        <a:ext cx="146532" cy="658368"/>
                      </a:xfrm>
                      <a:prstGeom prst="rect">
                        <a:avLst/>
                      </a:prstGeom>
                      <a:solidFill>
                        <a:schemeClr val="tx1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cxnSp>
                    <p:nvCxnSpPr>
                      <p:cNvPr id="253" name="Straight Connector 114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 rot="5400000">
                        <a:off x="5395182" y="5562767"/>
                        <a:ext cx="265176" cy="1695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254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5479070" y="5433667"/>
                        <a:ext cx="97588" cy="1010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  <p:cxnSp>
                    <p:nvCxnSpPr>
                      <p:cNvPr id="255" name="Straight Connector 115"/>
                      <p:cNvCxnSpPr>
                        <a:cxnSpLocks noChangeShapeType="1"/>
                      </p:cNvCxnSpPr>
                      <p:nvPr/>
                    </p:nvCxnSpPr>
                    <p:spPr bwMode="auto">
                      <a:xfrm>
                        <a:off x="5479631" y="5693249"/>
                        <a:ext cx="97588" cy="1010"/>
                      </a:xfrm>
                      <a:prstGeom prst="line">
                        <a:avLst/>
                      </a:prstGeom>
                      <a:noFill/>
                      <a:ln w="9525" algn="ctr">
                        <a:solidFill>
                          <a:schemeClr val="tx1"/>
                        </a:solidFill>
                        <a:round/>
                        <a:headEnd/>
                        <a:tailEnd/>
                      </a:ln>
                    </p:spPr>
                  </p:cxnSp>
                </p:grpSp>
                <p:cxnSp>
                  <p:nvCxnSpPr>
                    <p:cNvPr id="249" name="Straight Connector 248"/>
                    <p:cNvCxnSpPr/>
                    <p:nvPr/>
                  </p:nvCxnSpPr>
                  <p:spPr bwMode="auto">
                    <a:xfrm rot="5400000">
                      <a:off x="2890368" y="5893090"/>
                      <a:ext cx="45720" cy="1272"/>
                    </a:xfrm>
                    <a:prstGeom prst="line">
                      <a:avLst/>
                    </a:prstGeom>
                    <a:ln w="9525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250" name="TextBox 249"/>
                    <p:cNvSpPr txBox="1"/>
                    <p:nvPr/>
                  </p:nvSpPr>
                  <p:spPr>
                    <a:xfrm rot="18870653">
                      <a:off x="2786196" y="5889523"/>
                      <a:ext cx="44275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Grade3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245" name="TextBox 244"/>
                  <p:cNvSpPr txBox="1"/>
                  <p:nvPr/>
                </p:nvSpPr>
                <p:spPr>
                  <a:xfrm>
                    <a:off x="2256299" y="4945713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62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6" name="TextBox 245"/>
                  <p:cNvSpPr txBox="1"/>
                  <p:nvPr/>
                </p:nvSpPr>
                <p:spPr>
                  <a:xfrm>
                    <a:off x="2548275" y="4881966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39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7" name="TextBox 246"/>
                  <p:cNvSpPr txBox="1"/>
                  <p:nvPr/>
                </p:nvSpPr>
                <p:spPr>
                  <a:xfrm>
                    <a:off x="2855465" y="4892471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15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42" name="TextBox 241"/>
                <p:cNvSpPr txBox="1"/>
                <p:nvPr/>
              </p:nvSpPr>
              <p:spPr>
                <a:xfrm>
                  <a:off x="1597652" y="2541687"/>
                  <a:ext cx="30393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43" name="TextBox 242"/>
                <p:cNvSpPr txBox="1"/>
                <p:nvPr/>
              </p:nvSpPr>
              <p:spPr>
                <a:xfrm rot="16200000">
                  <a:off x="1372692" y="1979593"/>
                  <a:ext cx="377026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Arial" pitchFamily="34" charset="0"/>
                      <a:cs typeface="Arial" pitchFamily="34" charset="0"/>
                    </a:rPr>
                    <a:t>IRS</a:t>
                  </a:r>
                  <a:endParaRPr lang="en-IN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80" name="Left Brace 379"/>
              <p:cNvSpPr/>
              <p:nvPr/>
            </p:nvSpPr>
            <p:spPr>
              <a:xfrm rot="16200000" flipH="1" flipV="1">
                <a:off x="1003804" y="4868278"/>
                <a:ext cx="117771" cy="282585"/>
              </a:xfrm>
              <a:prstGeom prst="lef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1" name="TextBox 380"/>
              <p:cNvSpPr txBox="1"/>
              <p:nvPr/>
            </p:nvSpPr>
            <p:spPr>
              <a:xfrm>
                <a:off x="944756" y="4776002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84" name="Group 383"/>
            <p:cNvGrpSpPr/>
            <p:nvPr/>
          </p:nvGrpSpPr>
          <p:grpSpPr>
            <a:xfrm>
              <a:off x="2803286" y="4852214"/>
              <a:ext cx="972401" cy="1753362"/>
              <a:chOff x="2803286" y="4852214"/>
              <a:chExt cx="972401" cy="1753362"/>
            </a:xfrm>
          </p:grpSpPr>
          <p:grpSp>
            <p:nvGrpSpPr>
              <p:cNvPr id="291" name="Group 305"/>
              <p:cNvGrpSpPr/>
              <p:nvPr/>
            </p:nvGrpSpPr>
            <p:grpSpPr>
              <a:xfrm>
                <a:off x="2803286" y="4852214"/>
                <a:ext cx="951571" cy="1301404"/>
                <a:chOff x="5621788" y="1583384"/>
                <a:chExt cx="1268760" cy="1220459"/>
              </a:xfrm>
            </p:grpSpPr>
            <p:grpSp>
              <p:nvGrpSpPr>
                <p:cNvPr id="292" name="Group 306"/>
                <p:cNvGrpSpPr/>
                <p:nvPr/>
              </p:nvGrpSpPr>
              <p:grpSpPr>
                <a:xfrm>
                  <a:off x="5714264" y="1583384"/>
                  <a:ext cx="1176284" cy="1161181"/>
                  <a:chOff x="7294369" y="1234156"/>
                  <a:chExt cx="1176284" cy="1161181"/>
                </a:xfrm>
              </p:grpSpPr>
              <p:grpSp>
                <p:nvGrpSpPr>
                  <p:cNvPr id="295" name="Group 115"/>
                  <p:cNvGrpSpPr/>
                  <p:nvPr/>
                </p:nvGrpSpPr>
                <p:grpSpPr>
                  <a:xfrm>
                    <a:off x="7294369" y="1234156"/>
                    <a:ext cx="1103061" cy="1161181"/>
                    <a:chOff x="6272929" y="1166060"/>
                    <a:chExt cx="1103061" cy="1161181"/>
                  </a:xfrm>
                </p:grpSpPr>
                <p:grpSp>
                  <p:nvGrpSpPr>
                    <p:cNvPr id="298" name="Group 99"/>
                    <p:cNvGrpSpPr/>
                    <p:nvPr/>
                  </p:nvGrpSpPr>
                  <p:grpSpPr>
                    <a:xfrm>
                      <a:off x="6582254" y="1242690"/>
                      <a:ext cx="793736" cy="1084551"/>
                      <a:chOff x="6677255" y="1273655"/>
                      <a:chExt cx="1005840" cy="1828800"/>
                    </a:xfrm>
                  </p:grpSpPr>
                  <p:grpSp>
                    <p:nvGrpSpPr>
                      <p:cNvPr id="309" name="Group 55"/>
                      <p:cNvGrpSpPr/>
                      <p:nvPr/>
                    </p:nvGrpSpPr>
                    <p:grpSpPr>
                      <a:xfrm>
                        <a:off x="6677255" y="1273655"/>
                        <a:ext cx="1005840" cy="1828800"/>
                        <a:chOff x="1662446" y="1217592"/>
                        <a:chExt cx="1005840" cy="1828800"/>
                      </a:xfrm>
                    </p:grpSpPr>
                    <p:cxnSp>
                      <p:nvCxnSpPr>
                        <p:cNvPr id="312" name="Straight Connector 311"/>
                        <p:cNvCxnSpPr/>
                        <p:nvPr/>
                      </p:nvCxnSpPr>
                      <p:spPr>
                        <a:xfrm rot="5400000">
                          <a:off x="799394" y="2131991"/>
                          <a:ext cx="1828800" cy="1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  <p:sp>
                      <p:nvSpPr>
                        <p:cNvPr id="313" name="Rectangle 312"/>
                        <p:cNvSpPr/>
                        <p:nvPr/>
                      </p:nvSpPr>
                      <p:spPr>
                        <a:xfrm>
                          <a:off x="1919806" y="1874470"/>
                          <a:ext cx="182878" cy="1125577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314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1958405" y="1863041"/>
                          <a:ext cx="107932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15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945940" y="1804000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16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952292" y="1917342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sp>
                      <p:nvSpPr>
                        <p:cNvPr id="317" name="Rectangle 316"/>
                        <p:cNvSpPr/>
                        <p:nvPr/>
                      </p:nvSpPr>
                      <p:spPr>
                        <a:xfrm>
                          <a:off x="2370041" y="2041463"/>
                          <a:ext cx="182879" cy="955971"/>
                        </a:xfrm>
                        <a:prstGeom prst="rect">
                          <a:avLst/>
                        </a:prstGeom>
                        <a:solidFill>
                          <a:schemeClr val="tx1"/>
                        </a:solidFill>
                        <a:ln>
                          <a:noFill/>
                        </a:ln>
                      </p:spPr>
                      <p:style>
                        <a:lnRef idx="2">
                          <a:schemeClr val="accent1">
                            <a:shade val="50000"/>
                          </a:schemeClr>
                        </a:lnRef>
                        <a:fillRef idx="1">
                          <a:schemeClr val="accent1"/>
                        </a:fillRef>
                        <a:effectRef idx="0">
                          <a:schemeClr val="accent1"/>
                        </a:effectRef>
                        <a:fontRef idx="minor">
                          <a:schemeClr val="lt1"/>
                        </a:fontRef>
                      </p:style>
                      <p:txBody>
                        <a:bodyPr rtlCol="0" anchor="ctr"/>
                        <a:lstStyle/>
                        <a:p>
                          <a:pPr algn="ctr"/>
                          <a:endParaRPr lang="en-US">
                            <a:latin typeface="Arial" pitchFamily="34" charset="0"/>
                            <a:cs typeface="Arial" pitchFamily="34" charset="0"/>
                          </a:endParaRPr>
                        </a:p>
                      </p:txBody>
                    </p:sp>
                    <p:cxnSp>
                      <p:nvCxnSpPr>
                        <p:cNvPr id="318" name="Straight Connector 114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 rot="5400000">
                          <a:off x="2315870" y="2031927"/>
                          <a:ext cx="292959" cy="2115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19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391316" y="1879592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0" name="Straight Connector 115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2392015" y="2187853"/>
                          <a:ext cx="121795" cy="1587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1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9573" y="1226802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2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7380" y="1413700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3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15936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4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176892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5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194418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6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5828" y="2115637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7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29089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8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70136" y="246996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29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64522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30" name="Straight Connector 29"/>
                        <p:cNvCxnSpPr>
                          <a:cxnSpLocks noChangeShapeType="1"/>
                        </p:cNvCxnSpPr>
                        <p:nvPr/>
                      </p:nvCxnSpPr>
                      <p:spPr bwMode="auto">
                        <a:xfrm>
                          <a:off x="1666326" y="2816678"/>
                          <a:ext cx="48006" cy="1588"/>
                        </a:xfrm>
                        <a:prstGeom prst="line">
                          <a:avLst/>
                        </a:prstGeom>
                        <a:noFill/>
                        <a:ln w="9525" algn="ctr">
                          <a:solidFill>
                            <a:schemeClr val="tx1"/>
                          </a:solidFill>
                          <a:round/>
                          <a:headEnd/>
                          <a:tailEnd/>
                        </a:ln>
                      </p:spPr>
                    </p:cxnSp>
                    <p:cxnSp>
                      <p:nvCxnSpPr>
                        <p:cNvPr id="331" name="Straight Connector 330"/>
                        <p:cNvCxnSpPr/>
                        <p:nvPr/>
                      </p:nvCxnSpPr>
                      <p:spPr>
                        <a:xfrm rot="10800000">
                          <a:off x="1662446" y="2991693"/>
                          <a:ext cx="1005840" cy="1"/>
                        </a:xfrm>
                        <a:prstGeom prst="line">
                          <a:avLst/>
                        </a:prstGeom>
                        <a:ln w="9525"/>
                      </p:spPr>
                      <p:style>
                        <a:lnRef idx="1">
                          <a:schemeClr val="dk1"/>
                        </a:lnRef>
                        <a:fillRef idx="0">
                          <a:schemeClr val="dk1"/>
                        </a:fillRef>
                        <a:effectRef idx="0">
                          <a:schemeClr val="dk1"/>
                        </a:effectRef>
                        <a:fontRef idx="minor">
                          <a:schemeClr val="tx1"/>
                        </a:fontRef>
                      </p:style>
                    </p:cxnSp>
                  </p:grpSp>
                  <p:cxnSp>
                    <p:nvCxnSpPr>
                      <p:cNvPr id="310" name="Straight Connector 309"/>
                      <p:cNvCxnSpPr/>
                      <p:nvPr/>
                    </p:nvCxnSpPr>
                    <p:spPr bwMode="auto">
                      <a:xfrm rot="5400000">
                        <a:off x="7193800" y="3067920"/>
                        <a:ext cx="46493" cy="1588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311" name="Straight Connector 310"/>
                      <p:cNvCxnSpPr/>
                      <p:nvPr/>
                    </p:nvCxnSpPr>
                    <p:spPr bwMode="auto">
                      <a:xfrm rot="5400000">
                        <a:off x="7656613" y="3070613"/>
                        <a:ext cx="46493" cy="1588"/>
                      </a:xfrm>
                      <a:prstGeom prst="line">
                        <a:avLst/>
                      </a:prstGeom>
                      <a:ln w="952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299" name="TextBox 298"/>
                    <p:cNvSpPr txBox="1"/>
                    <p:nvPr/>
                  </p:nvSpPr>
                  <p:spPr>
                    <a:xfrm>
                      <a:off x="6313250" y="2105734"/>
                      <a:ext cx="36163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1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0" name="TextBox 299"/>
                    <p:cNvSpPr txBox="1"/>
                    <p:nvPr/>
                  </p:nvSpPr>
                  <p:spPr>
                    <a:xfrm>
                      <a:off x="6313247" y="2002758"/>
                      <a:ext cx="45571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2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1" name="TextBox 300"/>
                    <p:cNvSpPr txBox="1"/>
                    <p:nvPr/>
                  </p:nvSpPr>
                  <p:spPr>
                    <a:xfrm>
                      <a:off x="6313649" y="1899604"/>
                      <a:ext cx="455316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3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2" name="TextBox 301"/>
                    <p:cNvSpPr txBox="1"/>
                    <p:nvPr/>
                  </p:nvSpPr>
                  <p:spPr>
                    <a:xfrm>
                      <a:off x="6314086" y="1794175"/>
                      <a:ext cx="550129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4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3" name="TextBox 302"/>
                    <p:cNvSpPr txBox="1"/>
                    <p:nvPr/>
                  </p:nvSpPr>
                  <p:spPr>
                    <a:xfrm>
                      <a:off x="6314084" y="1691775"/>
                      <a:ext cx="64538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5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4" name="TextBox 303"/>
                    <p:cNvSpPr txBox="1"/>
                    <p:nvPr/>
                  </p:nvSpPr>
                  <p:spPr>
                    <a:xfrm>
                      <a:off x="6313612" y="1582728"/>
                      <a:ext cx="550605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6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5" name="TextBox 304"/>
                    <p:cNvSpPr txBox="1"/>
                    <p:nvPr/>
                  </p:nvSpPr>
                  <p:spPr>
                    <a:xfrm>
                      <a:off x="6313135" y="1482452"/>
                      <a:ext cx="455831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7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6" name="TextBox 305"/>
                    <p:cNvSpPr txBox="1"/>
                    <p:nvPr/>
                  </p:nvSpPr>
                  <p:spPr>
                    <a:xfrm>
                      <a:off x="6312182" y="1382176"/>
                      <a:ext cx="552033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8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7" name="TextBox 306"/>
                    <p:cNvSpPr txBox="1"/>
                    <p:nvPr/>
                  </p:nvSpPr>
                  <p:spPr>
                    <a:xfrm>
                      <a:off x="6311233" y="1278574"/>
                      <a:ext cx="457732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9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308" name="TextBox 307"/>
                    <p:cNvSpPr txBox="1"/>
                    <p:nvPr/>
                  </p:nvSpPr>
                  <p:spPr>
                    <a:xfrm>
                      <a:off x="6272929" y="1166060"/>
                      <a:ext cx="686537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dirty="0" smtClean="0">
                          <a:latin typeface="Arial" pitchFamily="34" charset="0"/>
                          <a:cs typeface="Arial" pitchFamily="34" charset="0"/>
                        </a:rPr>
                        <a:t>100</a:t>
                      </a:r>
                      <a:endParaRPr lang="en-US" sz="600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296" name="TextBox 295"/>
                  <p:cNvSpPr txBox="1"/>
                  <p:nvPr/>
                </p:nvSpPr>
                <p:spPr>
                  <a:xfrm>
                    <a:off x="7991461" y="1562472"/>
                    <a:ext cx="479192" cy="17318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40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97" name="TextBox 296"/>
                  <p:cNvSpPr txBox="1"/>
                  <p:nvPr/>
                </p:nvSpPr>
                <p:spPr>
                  <a:xfrm>
                    <a:off x="7651470" y="1517854"/>
                    <a:ext cx="479192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dirty="0" smtClean="0">
                        <a:latin typeface="Arial" pitchFamily="34" charset="0"/>
                        <a:cs typeface="Arial" pitchFamily="34" charset="0"/>
                      </a:rPr>
                      <a:t>n=76</a:t>
                    </a:r>
                    <a:endParaRPr lang="en-US" sz="600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93" name="TextBox 292"/>
                <p:cNvSpPr txBox="1"/>
                <p:nvPr/>
              </p:nvSpPr>
              <p:spPr>
                <a:xfrm>
                  <a:off x="5795805" y="2619177"/>
                  <a:ext cx="303931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dirty="0" smtClean="0">
                      <a:latin typeface="Arial" pitchFamily="34" charset="0"/>
                      <a:cs typeface="Arial" pitchFamily="34" charset="0"/>
                    </a:rPr>
                    <a:t>0</a:t>
                  </a:r>
                  <a:endParaRPr lang="en-US" sz="600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94" name="TextBox 293"/>
                <p:cNvSpPr txBox="1"/>
                <p:nvPr/>
              </p:nvSpPr>
              <p:spPr>
                <a:xfrm rot="16200000">
                  <a:off x="5587163" y="2067223"/>
                  <a:ext cx="377026" cy="30777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smtClean="0">
                      <a:latin typeface="Arial" pitchFamily="34" charset="0"/>
                      <a:cs typeface="Arial" pitchFamily="34" charset="0"/>
                    </a:rPr>
                    <a:t>IRS</a:t>
                  </a:r>
                  <a:endParaRPr lang="en-IN" sz="900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77" name="TextBox 376"/>
              <p:cNvSpPr txBox="1"/>
              <p:nvPr/>
            </p:nvSpPr>
            <p:spPr>
              <a:xfrm rot="18920517">
                <a:off x="3251700" y="6073594"/>
                <a:ext cx="523987" cy="1944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Positive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8" name="TextBox 122"/>
              <p:cNvSpPr txBox="1"/>
              <p:nvPr/>
            </p:nvSpPr>
            <p:spPr>
              <a:xfrm rot="18936178">
                <a:off x="2963394" y="6105662"/>
                <a:ext cx="490840" cy="1944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Negative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9" name="TextBox 378"/>
              <p:cNvSpPr txBox="1"/>
              <p:nvPr/>
            </p:nvSpPr>
            <p:spPr>
              <a:xfrm>
                <a:off x="3022689" y="6328577"/>
                <a:ext cx="7207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00" dirty="0" smtClean="0">
                    <a:latin typeface="Arial" pitchFamily="34" charset="0"/>
                    <a:cs typeface="Arial" pitchFamily="34" charset="0"/>
                  </a:rPr>
                  <a:t>Lymph node involvement</a:t>
                </a:r>
                <a:endParaRPr lang="en-US" sz="6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2" name="Left Brace 381"/>
              <p:cNvSpPr/>
              <p:nvPr/>
            </p:nvSpPr>
            <p:spPr>
              <a:xfrm rot="16200000" flipH="1" flipV="1">
                <a:off x="3387728" y="4995278"/>
                <a:ext cx="117771" cy="282585"/>
              </a:xfrm>
              <a:prstGeom prst="lef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3" name="TextBox 382"/>
              <p:cNvSpPr txBox="1"/>
              <p:nvPr/>
            </p:nvSpPr>
            <p:spPr>
              <a:xfrm>
                <a:off x="3328680" y="4896652"/>
                <a:ext cx="24397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en-US" sz="12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97" name="Group 396"/>
          <p:cNvGrpSpPr/>
          <p:nvPr/>
        </p:nvGrpSpPr>
        <p:grpSpPr>
          <a:xfrm>
            <a:off x="5232550" y="3408372"/>
            <a:ext cx="2625575" cy="3049548"/>
            <a:chOff x="4849008" y="3463019"/>
            <a:chExt cx="2625575" cy="3049548"/>
          </a:xfrm>
        </p:grpSpPr>
        <p:pic>
          <p:nvPicPr>
            <p:cNvPr id="387" name="Picture 386" descr="BT474 cyto.tif"/>
            <p:cNvPicPr>
              <a:picLocks noChangeAspect="1"/>
            </p:cNvPicPr>
            <p:nvPr/>
          </p:nvPicPr>
          <p:blipFill>
            <a:blip r:embed="rId33" cstate="print"/>
            <a:stretch>
              <a:fillRect/>
            </a:stretch>
          </p:blipFill>
          <p:spPr>
            <a:xfrm>
              <a:off x="4849008" y="3677352"/>
              <a:ext cx="1280160" cy="1280160"/>
            </a:xfrm>
            <a:prstGeom prst="rect">
              <a:avLst/>
            </a:prstGeom>
          </p:spPr>
        </p:pic>
        <p:pic>
          <p:nvPicPr>
            <p:cNvPr id="388" name="Picture 387" descr="MCF7 cyto.tif"/>
            <p:cNvPicPr>
              <a:picLocks noChangeAspect="1"/>
            </p:cNvPicPr>
            <p:nvPr/>
          </p:nvPicPr>
          <p:blipFill>
            <a:blip r:embed="rId34" cstate="print"/>
            <a:stretch>
              <a:fillRect/>
            </a:stretch>
          </p:blipFill>
          <p:spPr>
            <a:xfrm>
              <a:off x="6194423" y="3690034"/>
              <a:ext cx="1280160" cy="1280160"/>
            </a:xfrm>
            <a:prstGeom prst="rect">
              <a:avLst/>
            </a:prstGeom>
          </p:spPr>
        </p:pic>
        <p:pic>
          <p:nvPicPr>
            <p:cNvPr id="389" name="Picture 388" descr="MDA-MB-231 cyto.tif"/>
            <p:cNvPicPr>
              <a:picLocks noChangeAspect="1"/>
            </p:cNvPicPr>
            <p:nvPr/>
          </p:nvPicPr>
          <p:blipFill>
            <a:blip r:embed="rId35" cstate="print"/>
            <a:stretch>
              <a:fillRect/>
            </a:stretch>
          </p:blipFill>
          <p:spPr>
            <a:xfrm>
              <a:off x="4849008" y="5232407"/>
              <a:ext cx="1280160" cy="1280160"/>
            </a:xfrm>
            <a:prstGeom prst="rect">
              <a:avLst/>
            </a:prstGeom>
          </p:spPr>
        </p:pic>
        <p:pic>
          <p:nvPicPr>
            <p:cNvPr id="390" name="Picture 389" descr="SKBR3 cyto.tif"/>
            <p:cNvPicPr>
              <a:picLocks noChangeAspect="1"/>
            </p:cNvPicPr>
            <p:nvPr/>
          </p:nvPicPr>
          <p:blipFill>
            <a:blip r:embed="rId36" cstate="print"/>
            <a:stretch>
              <a:fillRect/>
            </a:stretch>
          </p:blipFill>
          <p:spPr>
            <a:xfrm>
              <a:off x="6194423" y="5232181"/>
              <a:ext cx="1280160" cy="1280160"/>
            </a:xfrm>
            <a:prstGeom prst="rect">
              <a:avLst/>
            </a:prstGeom>
          </p:spPr>
        </p:pic>
        <p:sp>
          <p:nvSpPr>
            <p:cNvPr id="391" name="TextBox 390"/>
            <p:cNvSpPr txBox="1"/>
            <p:nvPr/>
          </p:nvSpPr>
          <p:spPr>
            <a:xfrm>
              <a:off x="6328112" y="5000248"/>
              <a:ext cx="982249" cy="24622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 SK-BR-3</a:t>
              </a:r>
              <a:endParaRPr lang="en-IN" sz="10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2" name="Rectangle 391"/>
            <p:cNvSpPr/>
            <p:nvPr/>
          </p:nvSpPr>
          <p:spPr>
            <a:xfrm>
              <a:off x="5011658" y="3463019"/>
              <a:ext cx="1022350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BT-474</a:t>
              </a:r>
              <a:endParaRPr lang="en-US" sz="1000" dirty="0"/>
            </a:p>
          </p:txBody>
        </p:sp>
        <p:sp>
          <p:nvSpPr>
            <p:cNvPr id="393" name="Rectangle 392"/>
            <p:cNvSpPr/>
            <p:nvPr/>
          </p:nvSpPr>
          <p:spPr>
            <a:xfrm>
              <a:off x="6549299" y="3482062"/>
              <a:ext cx="56938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CF7 </a:t>
              </a:r>
              <a:endParaRPr lang="en-US" sz="1000" dirty="0"/>
            </a:p>
          </p:txBody>
        </p:sp>
        <p:sp>
          <p:nvSpPr>
            <p:cNvPr id="395" name="Rectangle 394"/>
            <p:cNvSpPr/>
            <p:nvPr/>
          </p:nvSpPr>
          <p:spPr>
            <a:xfrm>
              <a:off x="4997370" y="5002060"/>
              <a:ext cx="1031051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1000" smtClean="0">
                  <a:latin typeface="Arial" pitchFamily="34" charset="0"/>
                  <a:cs typeface="Arial" pitchFamily="34" charset="0"/>
                </a:rPr>
                <a:t>MDA-MB-231 </a:t>
              </a:r>
              <a:endParaRPr lang="en-US" sz="1000" dirty="0"/>
            </a:p>
          </p:txBody>
        </p:sp>
      </p:grpSp>
      <p:sp>
        <p:nvSpPr>
          <p:cNvPr id="398" name="TextBox 199"/>
          <p:cNvSpPr txBox="1">
            <a:spLocks noChangeArrowheads="1"/>
          </p:cNvSpPr>
          <p:nvPr/>
        </p:nvSpPr>
        <p:spPr bwMode="auto">
          <a:xfrm>
            <a:off x="4878560" y="3332862"/>
            <a:ext cx="25519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e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9" name="TextBox 199"/>
          <p:cNvSpPr txBox="1">
            <a:spLocks noChangeArrowheads="1"/>
          </p:cNvSpPr>
          <p:nvPr/>
        </p:nvSpPr>
        <p:spPr bwMode="auto">
          <a:xfrm>
            <a:off x="44450" y="3328829"/>
            <a:ext cx="26321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251786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0</Words>
  <Application>Microsoft Office PowerPoint</Application>
  <PresentationFormat>On-screen Show (4:3)</PresentationFormat>
  <Paragraphs>1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AnilSuri</dc:creator>
  <cp:lastModifiedBy>Admin</cp:lastModifiedBy>
  <cp:revision>5</cp:revision>
  <dcterms:created xsi:type="dcterms:W3CDTF">2016-05-27T11:44:42Z</dcterms:created>
  <dcterms:modified xsi:type="dcterms:W3CDTF">2016-06-13T16:06:36Z</dcterms:modified>
</cp:coreProperties>
</file>